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558" r:id="rId2"/>
    <p:sldId id="537" r:id="rId3"/>
    <p:sldId id="565" r:id="rId4"/>
    <p:sldId id="559" r:id="rId5"/>
    <p:sldId id="560" r:id="rId6"/>
    <p:sldId id="561" r:id="rId7"/>
    <p:sldId id="562" r:id="rId8"/>
    <p:sldId id="564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6735"/>
  </p:normalViewPr>
  <p:slideViewPr>
    <p:cSldViewPr snapToGrid="0" snapToObjects="1" showGuides="1">
      <p:cViewPr varScale="1">
        <p:scale>
          <a:sx n="106" d="100"/>
          <a:sy n="106" d="100"/>
        </p:scale>
        <p:origin x="1240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ola.a/Desktop/Data_from_old_flash/Pv_PNG_haplotypes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75"/>
      <c:rotY val="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1.4886669631607072E-2"/>
          <c:y val="9.6608628128412848E-3"/>
          <c:w val="0.85132646880678375"/>
          <c:h val="0.98438028579760861"/>
        </c:manualLayout>
      </c:layout>
      <c:pie3DChart>
        <c:varyColors val="1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chemeClr val="accent4">
                  <a:lumMod val="50000"/>
                </a:schemeClr>
              </a:solidFill>
            </a:ln>
          </c:spPr>
          <c:dPt>
            <c:idx val="0"/>
            <c:bubble3D val="0"/>
            <c:spPr>
              <a:solidFill>
                <a:schemeClr val="bg1">
                  <a:lumMod val="50000"/>
                </a:schemeClr>
              </a:solidFill>
              <a:ln w="25400">
                <a:solidFill>
                  <a:schemeClr val="accent4">
                    <a:lumMod val="50000"/>
                  </a:schemeClr>
                </a:solidFill>
              </a:ln>
              <a:effectLst/>
              <a:sp3d contourW="25400">
                <a:contourClr>
                  <a:schemeClr val="accent4">
                    <a:lumMod val="50000"/>
                  </a:schemeClr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CF0D-1848-9C79-97192E3A55D3}"/>
              </c:ext>
            </c:extLst>
          </c:dPt>
          <c:dPt>
            <c:idx val="1"/>
            <c:bubble3D val="0"/>
            <c:spPr>
              <a:solidFill>
                <a:schemeClr val="bg2">
                  <a:lumMod val="50000"/>
                </a:schemeClr>
              </a:solidFill>
              <a:ln w="25400">
                <a:solidFill>
                  <a:schemeClr val="accent4">
                    <a:lumMod val="50000"/>
                  </a:schemeClr>
                </a:solidFill>
              </a:ln>
              <a:effectLst/>
              <a:sp3d contourW="25400">
                <a:contourClr>
                  <a:schemeClr val="accent4">
                    <a:lumMod val="50000"/>
                  </a:schemeClr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CF0D-1848-9C79-97192E3A55D3}"/>
              </c:ext>
            </c:extLst>
          </c:dPt>
          <c:dPt>
            <c:idx val="2"/>
            <c:bubble3D val="0"/>
            <c:spPr>
              <a:solidFill>
                <a:schemeClr val="tx1"/>
              </a:solidFill>
              <a:ln w="25400">
                <a:solidFill>
                  <a:schemeClr val="accent4">
                    <a:lumMod val="50000"/>
                  </a:schemeClr>
                </a:solidFill>
              </a:ln>
              <a:effectLst/>
              <a:sp3d contourW="25400">
                <a:contourClr>
                  <a:schemeClr val="accent4">
                    <a:lumMod val="50000"/>
                  </a:schemeClr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CF0D-1848-9C79-97192E3A55D3}"/>
              </c:ext>
            </c:extLst>
          </c:dPt>
          <c:dPt>
            <c:idx val="3"/>
            <c:bubble3D val="0"/>
            <c:spPr>
              <a:solidFill>
                <a:schemeClr val="bg2">
                  <a:lumMod val="50000"/>
                </a:schemeClr>
              </a:solidFill>
              <a:ln w="25400">
                <a:solidFill>
                  <a:schemeClr val="accent4">
                    <a:lumMod val="50000"/>
                  </a:schemeClr>
                </a:solidFill>
              </a:ln>
              <a:effectLst/>
              <a:sp3d contourW="25400">
                <a:contourClr>
                  <a:schemeClr val="accent4">
                    <a:lumMod val="50000"/>
                  </a:schemeClr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CF0D-1848-9C79-97192E3A55D3}"/>
              </c:ext>
            </c:extLst>
          </c:dPt>
          <c:val>
            <c:numRef>
              <c:f>Pv_PNG_haplotypes!$S$20:$S$23</c:f>
              <c:numCache>
                <c:formatCode>General</c:formatCode>
                <c:ptCount val="4"/>
                <c:pt idx="0">
                  <c:v>178</c:v>
                </c:pt>
                <c:pt idx="2">
                  <c:v>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F0D-1848-9C79-97192E3A55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4">
  <dgm:title val=""/>
  <dgm:desc val=""/>
  <dgm:catLst>
    <dgm:cat type="colorful" pri="104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/>
      <a:schemeClr val="accent5"/>
    </dgm:fillClrLst>
    <dgm:linClrLst>
      <a:schemeClr val="accent4"/>
      <a:schemeClr val="accent5"/>
    </dgm:linClrLst>
    <dgm:effectClrLst/>
    <dgm:txLinClrLst/>
    <dgm:txFillClrLst/>
    <dgm:txEffectClrLst/>
  </dgm:styleLbl>
  <dgm:styleLbl name="ln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alpha val="50000"/>
      </a:schemeClr>
      <a:schemeClr val="accent5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4"/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5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22D785ED-2458-C645-9C88-AEC01571BDB4}" type="doc">
      <dgm:prSet loTypeId="urn:microsoft.com/office/officeart/2005/8/layout/process4" loCatId="Inbox" qsTypeId="urn:microsoft.com/office/officeart/2005/8/quickstyle/simple3" qsCatId="simple" csTypeId="urn:microsoft.com/office/officeart/2005/8/colors/colorful4" csCatId="colorful" phldr="1"/>
      <dgm:spPr/>
      <dgm:t>
        <a:bodyPr/>
        <a:lstStyle/>
        <a:p>
          <a:endParaRPr lang="en-US"/>
        </a:p>
      </dgm:t>
    </dgm:pt>
    <dgm:pt modelId="{34352E99-AE67-2347-9C44-F5A818DCCFD5}">
      <dgm:prSet phldrT="[Text]" custT="1"/>
      <dgm:spPr>
        <a:xfrm>
          <a:off x="66282" y="51079"/>
          <a:ext cx="1204419" cy="722651"/>
        </a:xfrm>
      </dgm:spPr>
      <dgm:t>
        <a:bodyPr/>
        <a:lstStyle/>
        <a:p>
          <a:pPr algn="ctr">
            <a:buNone/>
          </a:pPr>
          <a:r>
            <a:rPr lang="en-US" sz="1600" b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Demultiplexing samples based on Index</a:t>
          </a:r>
        </a:p>
      </dgm:t>
    </dgm:pt>
    <dgm:pt modelId="{0A35CF53-5D65-B84D-80F8-F7B1FE822C34}" type="parTrans" cxnId="{FBF90D3B-ACC9-DC47-8D1B-7ABF3802013F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66C986F8-818E-4342-8565-B53E218896FE}" type="sibTrans" cxnId="{FBF90D3B-ACC9-DC47-8D1B-7ABF3802013F}">
      <dgm:prSet/>
      <dgm:spPr>
        <a:xfrm rot="16199560" flipV="1">
          <a:off x="-167843" y="663165"/>
          <a:ext cx="895782" cy="38250"/>
        </a:xfrm>
      </dgm:spPr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  <a:highlight>
              <a:srgbClr val="FFFF00"/>
            </a:highlight>
          </a:endParaRPr>
        </a:p>
      </dgm:t>
    </dgm:pt>
    <dgm:pt modelId="{82CE170F-83C5-BE41-A86A-56B8D6DE445D}">
      <dgm:prSet phldrT="[Text]" custT="1"/>
      <dgm:spPr>
        <a:xfrm>
          <a:off x="2219" y="1857708"/>
          <a:ext cx="1204419" cy="722651"/>
        </a:xfrm>
      </dgm:spPr>
      <dgm:t>
        <a:bodyPr/>
        <a:lstStyle/>
        <a:p>
          <a:pPr algn="ctr">
            <a:buNone/>
          </a:pPr>
          <a:r>
            <a:rPr lang="en-US" sz="1600" b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Mapping/Aligning  to reference sequence using </a:t>
          </a:r>
          <a:r>
            <a:rPr lang="en-US" sz="1600" b="0" i="1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bwa-mem</a:t>
          </a:r>
        </a:p>
      </dgm:t>
    </dgm:pt>
    <dgm:pt modelId="{F5A10637-8484-2C4A-A136-E2039FED2564}" type="parTrans" cxnId="{CE67BF73-3EC0-7A41-AF7C-F72B67C831FC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34568C00-807F-644D-A571-B7C7E775E976}" type="sibTrans" cxnId="{CE67BF73-3EC0-7A41-AF7C-F72B67C831FC}">
      <dgm:prSet/>
      <dgm:spPr>
        <a:xfrm rot="21599953">
          <a:off x="252929" y="2018126"/>
          <a:ext cx="1569758" cy="38250"/>
        </a:xfrm>
      </dgm:spPr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EC2874FC-CD24-FB44-A965-D0F87D1E54EB}">
      <dgm:prSet custT="1"/>
      <dgm:spPr>
        <a:xfrm>
          <a:off x="1604097" y="51079"/>
          <a:ext cx="1204419" cy="722651"/>
        </a:xfrm>
      </dgm:spPr>
      <dgm:t>
        <a:bodyPr/>
        <a:lstStyle/>
        <a:p>
          <a:pPr algn="ctr">
            <a:buNone/>
          </a:pPr>
          <a:r>
            <a:rPr lang="en-US" sz="1600" b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SNP filtering using </a:t>
          </a:r>
          <a:r>
            <a:rPr lang="en-US" sz="1600" b="0" i="1" dirty="0" err="1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vcftools</a:t>
          </a:r>
          <a:endParaRPr lang="en-US" sz="1600" b="0" i="1" dirty="0">
            <a:ln/>
            <a:latin typeface="Arial" panose="020B0604020202020204" pitchFamily="34" charset="0"/>
            <a:ea typeface="+mn-ea"/>
            <a:cs typeface="Arial" panose="020B0604020202020204" pitchFamily="34" charset="0"/>
          </a:endParaRPr>
        </a:p>
      </dgm:t>
    </dgm:pt>
    <dgm:pt modelId="{B7D28377-1A52-8344-A503-096F66DAA895}" type="parTrans" cxnId="{EE7E1EAE-999F-EA42-B2FA-BDEB11143B7F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342CB228-7E35-004F-AF45-AF618BE16610}" type="sibTrans" cxnId="{EE7E1EAE-999F-EA42-B2FA-BDEB11143B7F}">
      <dgm:prSet/>
      <dgm:spPr>
        <a:xfrm>
          <a:off x="1854807" y="211507"/>
          <a:ext cx="1592052" cy="38250"/>
        </a:xfrm>
      </dgm:spPr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F3986F6A-7CC2-D646-82F5-D979C46EE6D3}">
      <dgm:prSet custT="1"/>
      <dgm:spPr>
        <a:xfrm>
          <a:off x="3205975" y="51079"/>
          <a:ext cx="1204419" cy="722651"/>
        </a:xfrm>
      </dgm:spPr>
      <dgm:t>
        <a:bodyPr/>
        <a:lstStyle/>
        <a:p>
          <a:pPr algn="ctr">
            <a:buNone/>
          </a:pPr>
          <a:r>
            <a:rPr lang="en-US" sz="1600" b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Population genetics and statistical analyses </a:t>
          </a:r>
        </a:p>
      </dgm:t>
    </dgm:pt>
    <dgm:pt modelId="{B61606D3-9623-434C-A3C0-3333DEAE98A9}" type="parTrans" cxnId="{BCFF3C70-5265-0145-81B0-E3D1F57260B7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5FABB3FF-6080-F44A-86B9-C5EA8A1B4AFD}" type="sibTrans" cxnId="{BCFF3C70-5265-0145-81B0-E3D1F57260B7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715087EC-6147-9346-BC8A-9970904E7611}">
      <dgm:prSet custT="1"/>
      <dgm:spPr>
        <a:xfrm>
          <a:off x="2219" y="954394"/>
          <a:ext cx="1204419" cy="722651"/>
        </a:xfrm>
      </dgm:spPr>
      <dgm:t>
        <a:bodyPr/>
        <a:lstStyle/>
        <a:p>
          <a:pPr algn="ctr">
            <a:buNone/>
          </a:pPr>
          <a:r>
            <a:rPr lang="en-US" sz="1600" b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Quality checking using </a:t>
          </a:r>
          <a:r>
            <a:rPr lang="en-US" sz="1600" b="0" i="1" dirty="0" err="1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Fastqc</a:t>
          </a:r>
          <a:r>
            <a:rPr lang="en-US" sz="1600" b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  and trimming using Trimmomatic</a:t>
          </a:r>
          <a:endParaRPr lang="en-US" sz="1600" dirty="0">
            <a:ln/>
            <a:latin typeface="Arial" panose="020B0604020202020204" pitchFamily="34" charset="0"/>
            <a:ea typeface="+mn-ea"/>
            <a:cs typeface="Arial" panose="020B0604020202020204" pitchFamily="34" charset="0"/>
          </a:endParaRPr>
        </a:p>
      </dgm:t>
    </dgm:pt>
    <dgm:pt modelId="{F4A58142-1F18-494D-A932-5DCCD1936D8C}" type="parTrans" cxnId="{F412369A-99BC-3B46-A931-1B7590800AE8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D443C565-860E-EF42-9197-07383520AE24}" type="sibTrans" cxnId="{F412369A-99BC-3B46-A931-1B7590800AE8}">
      <dgm:prSet/>
      <dgm:spPr>
        <a:xfrm rot="5400000">
          <a:off x="-198728" y="1560816"/>
          <a:ext cx="893488" cy="49577"/>
        </a:xfrm>
      </dgm:spPr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6104E1E5-D574-B948-8021-AADD13D0A13A}">
      <dgm:prSet phldrT="[Text]" custT="1"/>
      <dgm:spPr>
        <a:xfrm>
          <a:off x="1581803" y="1857687"/>
          <a:ext cx="1204419" cy="722651"/>
        </a:xfrm>
      </dgm:spPr>
      <dgm:t>
        <a:bodyPr/>
        <a:lstStyle/>
        <a:p>
          <a:pPr algn="ctr">
            <a:buNone/>
          </a:pPr>
          <a:r>
            <a:rPr lang="en-US" sz="1600" b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Collect summary statistics using </a:t>
          </a:r>
          <a:r>
            <a:rPr lang="en-US" sz="1600" b="0" i="1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qualimap</a:t>
          </a:r>
        </a:p>
      </dgm:t>
    </dgm:pt>
    <dgm:pt modelId="{5D6B20A1-D0DB-CD4A-A3C6-AFE571A2F33F}" type="sibTrans" cxnId="{8156CC3C-981E-8845-BC0B-24650EFF3FB1}">
      <dgm:prSet/>
      <dgm:spPr>
        <a:xfrm rot="16266501">
          <a:off x="1391930" y="1568925"/>
          <a:ext cx="898548" cy="38250"/>
        </a:xfrm>
      </dgm:spPr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B2B32AAB-0B79-D849-B152-BF11F3287A88}" type="parTrans" cxnId="{8156CC3C-981E-8845-BC0B-24650EFF3FB1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D1984497-29B1-1044-8DE8-70CA696079F1}">
      <dgm:prSet custT="1"/>
      <dgm:spPr>
        <a:xfrm>
          <a:off x="1604097" y="954394"/>
          <a:ext cx="1204419" cy="722651"/>
        </a:xfrm>
        <a:gradFill rotWithShape="0">
          <a:gsLst>
            <a:gs pos="0">
              <a:schemeClr val="accent4">
                <a:hueOff val="3266964"/>
                <a:satOff val="-13592"/>
                <a:lumOff val="3203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3266964"/>
                <a:satOff val="-13592"/>
                <a:lumOff val="3203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3266964"/>
                <a:satOff val="-13592"/>
                <a:lumOff val="3203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</dgm:spPr>
      <dgm:t>
        <a:bodyPr/>
        <a:lstStyle/>
        <a:p>
          <a:pPr algn="ctr">
            <a:buNone/>
          </a:pPr>
          <a:r>
            <a:rPr lang="en-US" sz="1600" b="0" i="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SNP calling using samtools </a:t>
          </a:r>
          <a:r>
            <a:rPr lang="en-US" sz="1600" b="0" i="1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mpileup</a:t>
          </a:r>
        </a:p>
      </dgm:t>
    </dgm:pt>
    <dgm:pt modelId="{5A950B5D-8930-084A-995B-1A5BF7E5CFE4}" type="sibTrans" cxnId="{ADC252CA-4324-BF43-A2E8-7E0A1EDB8AB2}">
      <dgm:prSet/>
      <dgm:spPr>
        <a:xfrm rot="5400000" flipV="1">
          <a:off x="1403150" y="663165"/>
          <a:ext cx="893488" cy="38250"/>
        </a:xfrm>
      </dgm:spPr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1086CD3A-EF0D-A54F-962F-C03ED22C7E4A}" type="parTrans" cxnId="{ADC252CA-4324-BF43-A2E8-7E0A1EDB8AB2}">
      <dgm:prSet/>
      <dgm:spPr/>
      <dgm:t>
        <a:bodyPr/>
        <a:lstStyle/>
        <a:p>
          <a:pPr algn="ctr"/>
          <a:endParaRPr lang="en-US">
            <a:ln>
              <a:noFill/>
            </a:ln>
            <a:solidFill>
              <a:schemeClr val="tx1"/>
            </a:solidFill>
          </a:endParaRPr>
        </a:p>
      </dgm:t>
    </dgm:pt>
    <dgm:pt modelId="{5271C860-0FEC-CA47-9DF1-EF4DE2253301}" type="pres">
      <dgm:prSet presAssocID="{22D785ED-2458-C645-9C88-AEC01571BDB4}" presName="Name0" presStyleCnt="0">
        <dgm:presLayoutVars>
          <dgm:dir/>
          <dgm:animLvl val="lvl"/>
          <dgm:resizeHandles val="exact"/>
        </dgm:presLayoutVars>
      </dgm:prSet>
      <dgm:spPr/>
    </dgm:pt>
    <dgm:pt modelId="{7868ABE0-931E-8A4D-8856-875F3A2FFEF5}" type="pres">
      <dgm:prSet presAssocID="{F3986F6A-7CC2-D646-82F5-D979C46EE6D3}" presName="boxAndChildren" presStyleCnt="0"/>
      <dgm:spPr/>
    </dgm:pt>
    <dgm:pt modelId="{6CCDF85D-8B2C-8044-BBAA-824965846F17}" type="pres">
      <dgm:prSet presAssocID="{F3986F6A-7CC2-D646-82F5-D979C46EE6D3}" presName="parentTextBox" presStyleLbl="node1" presStyleIdx="0" presStyleCnt="7"/>
      <dgm:spPr/>
    </dgm:pt>
    <dgm:pt modelId="{78CB3A80-F8DE-9240-B056-A34BB9D3F442}" type="pres">
      <dgm:prSet presAssocID="{342CB228-7E35-004F-AF45-AF618BE16610}" presName="sp" presStyleCnt="0"/>
      <dgm:spPr/>
    </dgm:pt>
    <dgm:pt modelId="{0A28C592-CB4A-0B44-A06A-0B564A25C534}" type="pres">
      <dgm:prSet presAssocID="{EC2874FC-CD24-FB44-A965-D0F87D1E54EB}" presName="arrowAndChildren" presStyleCnt="0"/>
      <dgm:spPr/>
    </dgm:pt>
    <dgm:pt modelId="{2B80C3A1-24DB-5545-AA64-14D53FB503FE}" type="pres">
      <dgm:prSet presAssocID="{EC2874FC-CD24-FB44-A965-D0F87D1E54EB}" presName="parentTextArrow" presStyleLbl="node1" presStyleIdx="1" presStyleCnt="7"/>
      <dgm:spPr/>
    </dgm:pt>
    <dgm:pt modelId="{A451EBAA-0D78-7D48-BF71-A0DF54BB0863}" type="pres">
      <dgm:prSet presAssocID="{5A950B5D-8930-084A-995B-1A5BF7E5CFE4}" presName="sp" presStyleCnt="0"/>
      <dgm:spPr/>
    </dgm:pt>
    <dgm:pt modelId="{EB9ED6DD-FFD7-4945-BE25-E36CC148017B}" type="pres">
      <dgm:prSet presAssocID="{D1984497-29B1-1044-8DE8-70CA696079F1}" presName="arrowAndChildren" presStyleCnt="0"/>
      <dgm:spPr/>
    </dgm:pt>
    <dgm:pt modelId="{6F065D3D-85A0-6542-8141-D9721674AD75}" type="pres">
      <dgm:prSet presAssocID="{D1984497-29B1-1044-8DE8-70CA696079F1}" presName="parentTextArrow" presStyleLbl="node1" presStyleIdx="2" presStyleCnt="7"/>
      <dgm:spPr/>
    </dgm:pt>
    <dgm:pt modelId="{1B120042-B04E-F848-888A-819DE310FAD5}" type="pres">
      <dgm:prSet presAssocID="{5D6B20A1-D0DB-CD4A-A3C6-AFE571A2F33F}" presName="sp" presStyleCnt="0"/>
      <dgm:spPr/>
    </dgm:pt>
    <dgm:pt modelId="{C27FD0DE-7753-B24C-BF73-665111039FA1}" type="pres">
      <dgm:prSet presAssocID="{6104E1E5-D574-B948-8021-AADD13D0A13A}" presName="arrowAndChildren" presStyleCnt="0"/>
      <dgm:spPr/>
    </dgm:pt>
    <dgm:pt modelId="{06ECA7A6-D276-8B41-BB68-0CDC838D6D31}" type="pres">
      <dgm:prSet presAssocID="{6104E1E5-D574-B948-8021-AADD13D0A13A}" presName="parentTextArrow" presStyleLbl="node1" presStyleIdx="3" presStyleCnt="7"/>
      <dgm:spPr/>
    </dgm:pt>
    <dgm:pt modelId="{AB7AA94D-3D52-B640-B79A-183EC311D9E8}" type="pres">
      <dgm:prSet presAssocID="{34568C00-807F-644D-A571-B7C7E775E976}" presName="sp" presStyleCnt="0"/>
      <dgm:spPr/>
    </dgm:pt>
    <dgm:pt modelId="{1AE1985C-2EB9-3041-87F5-531D2324CB46}" type="pres">
      <dgm:prSet presAssocID="{82CE170F-83C5-BE41-A86A-56B8D6DE445D}" presName="arrowAndChildren" presStyleCnt="0"/>
      <dgm:spPr/>
    </dgm:pt>
    <dgm:pt modelId="{F7F1675C-641E-654C-9FD9-CC54C676BCC8}" type="pres">
      <dgm:prSet presAssocID="{82CE170F-83C5-BE41-A86A-56B8D6DE445D}" presName="parentTextArrow" presStyleLbl="node1" presStyleIdx="4" presStyleCnt="7"/>
      <dgm:spPr/>
    </dgm:pt>
    <dgm:pt modelId="{B02069EA-A275-F643-AB0E-9542A8F5AD00}" type="pres">
      <dgm:prSet presAssocID="{D443C565-860E-EF42-9197-07383520AE24}" presName="sp" presStyleCnt="0"/>
      <dgm:spPr/>
    </dgm:pt>
    <dgm:pt modelId="{6B63C600-E196-9545-89CC-67A25E2D0AB5}" type="pres">
      <dgm:prSet presAssocID="{715087EC-6147-9346-BC8A-9970904E7611}" presName="arrowAndChildren" presStyleCnt="0"/>
      <dgm:spPr/>
    </dgm:pt>
    <dgm:pt modelId="{100D4726-FE18-1642-BA58-2471DB0A197F}" type="pres">
      <dgm:prSet presAssocID="{715087EC-6147-9346-BC8A-9970904E7611}" presName="parentTextArrow" presStyleLbl="node1" presStyleIdx="5" presStyleCnt="7"/>
      <dgm:spPr/>
    </dgm:pt>
    <dgm:pt modelId="{21190727-1C8E-6344-989E-18E5785F3097}" type="pres">
      <dgm:prSet presAssocID="{66C986F8-818E-4342-8565-B53E218896FE}" presName="sp" presStyleCnt="0"/>
      <dgm:spPr/>
    </dgm:pt>
    <dgm:pt modelId="{9D5EA433-AAC3-1B49-B95C-01EBA21FC126}" type="pres">
      <dgm:prSet presAssocID="{34352E99-AE67-2347-9C44-F5A818DCCFD5}" presName="arrowAndChildren" presStyleCnt="0"/>
      <dgm:spPr/>
    </dgm:pt>
    <dgm:pt modelId="{614BB742-D0A2-2D44-B25E-019A363908CD}" type="pres">
      <dgm:prSet presAssocID="{34352E99-AE67-2347-9C44-F5A818DCCFD5}" presName="parentTextArrow" presStyleLbl="node1" presStyleIdx="6" presStyleCnt="7" custLinFactNeighborX="-4594" custLinFactNeighborY="-5370"/>
      <dgm:spPr/>
    </dgm:pt>
  </dgm:ptLst>
  <dgm:cxnLst>
    <dgm:cxn modelId="{A3145B1D-3942-9046-948C-9287ADEFC30A}" type="presOf" srcId="{F3986F6A-7CC2-D646-82F5-D979C46EE6D3}" destId="{6CCDF85D-8B2C-8044-BBAA-824965846F17}" srcOrd="0" destOrd="0" presId="urn:microsoft.com/office/officeart/2005/8/layout/process4"/>
    <dgm:cxn modelId="{FBF90D3B-ACC9-DC47-8D1B-7ABF3802013F}" srcId="{22D785ED-2458-C645-9C88-AEC01571BDB4}" destId="{34352E99-AE67-2347-9C44-F5A818DCCFD5}" srcOrd="0" destOrd="0" parTransId="{0A35CF53-5D65-B84D-80F8-F7B1FE822C34}" sibTransId="{66C986F8-818E-4342-8565-B53E218896FE}"/>
    <dgm:cxn modelId="{8156CC3C-981E-8845-BC0B-24650EFF3FB1}" srcId="{22D785ED-2458-C645-9C88-AEC01571BDB4}" destId="{6104E1E5-D574-B948-8021-AADD13D0A13A}" srcOrd="3" destOrd="0" parTransId="{B2B32AAB-0B79-D849-B152-BF11F3287A88}" sibTransId="{5D6B20A1-D0DB-CD4A-A3C6-AFE571A2F33F}"/>
    <dgm:cxn modelId="{3FB5BA44-7059-1E49-9FBA-1C75A92E45B7}" type="presOf" srcId="{715087EC-6147-9346-BC8A-9970904E7611}" destId="{100D4726-FE18-1642-BA58-2471DB0A197F}" srcOrd="0" destOrd="0" presId="urn:microsoft.com/office/officeart/2005/8/layout/process4"/>
    <dgm:cxn modelId="{B1F2B94B-BFCF-D944-BC7B-1C829CA1AE56}" type="presOf" srcId="{82CE170F-83C5-BE41-A86A-56B8D6DE445D}" destId="{F7F1675C-641E-654C-9FD9-CC54C676BCC8}" srcOrd="0" destOrd="0" presId="urn:microsoft.com/office/officeart/2005/8/layout/process4"/>
    <dgm:cxn modelId="{BD2E0A60-2F01-6744-A2FD-4C22EAA5E937}" type="presOf" srcId="{34352E99-AE67-2347-9C44-F5A818DCCFD5}" destId="{614BB742-D0A2-2D44-B25E-019A363908CD}" srcOrd="0" destOrd="0" presId="urn:microsoft.com/office/officeart/2005/8/layout/process4"/>
    <dgm:cxn modelId="{BCFF3C70-5265-0145-81B0-E3D1F57260B7}" srcId="{22D785ED-2458-C645-9C88-AEC01571BDB4}" destId="{F3986F6A-7CC2-D646-82F5-D979C46EE6D3}" srcOrd="6" destOrd="0" parTransId="{B61606D3-9623-434C-A3C0-3333DEAE98A9}" sibTransId="{5FABB3FF-6080-F44A-86B9-C5EA8A1B4AFD}"/>
    <dgm:cxn modelId="{CE67BF73-3EC0-7A41-AF7C-F72B67C831FC}" srcId="{22D785ED-2458-C645-9C88-AEC01571BDB4}" destId="{82CE170F-83C5-BE41-A86A-56B8D6DE445D}" srcOrd="2" destOrd="0" parTransId="{F5A10637-8484-2C4A-A136-E2039FED2564}" sibTransId="{34568C00-807F-644D-A571-B7C7E775E976}"/>
    <dgm:cxn modelId="{F412369A-99BC-3B46-A931-1B7590800AE8}" srcId="{22D785ED-2458-C645-9C88-AEC01571BDB4}" destId="{715087EC-6147-9346-BC8A-9970904E7611}" srcOrd="1" destOrd="0" parTransId="{F4A58142-1F18-494D-A932-5DCCD1936D8C}" sibTransId="{D443C565-860E-EF42-9197-07383520AE24}"/>
    <dgm:cxn modelId="{EE7E1EAE-999F-EA42-B2FA-BDEB11143B7F}" srcId="{22D785ED-2458-C645-9C88-AEC01571BDB4}" destId="{EC2874FC-CD24-FB44-A965-D0F87D1E54EB}" srcOrd="5" destOrd="0" parTransId="{B7D28377-1A52-8344-A503-096F66DAA895}" sibTransId="{342CB228-7E35-004F-AF45-AF618BE16610}"/>
    <dgm:cxn modelId="{CCF935AF-C10A-464E-A6AA-B540061EC702}" type="presOf" srcId="{6104E1E5-D574-B948-8021-AADD13D0A13A}" destId="{06ECA7A6-D276-8B41-BB68-0CDC838D6D31}" srcOrd="0" destOrd="0" presId="urn:microsoft.com/office/officeart/2005/8/layout/process4"/>
    <dgm:cxn modelId="{E86C34B3-F019-2843-8D01-1C89BE7BC9DA}" type="presOf" srcId="{D1984497-29B1-1044-8DE8-70CA696079F1}" destId="{6F065D3D-85A0-6542-8141-D9721674AD75}" srcOrd="0" destOrd="0" presId="urn:microsoft.com/office/officeart/2005/8/layout/process4"/>
    <dgm:cxn modelId="{ADC252CA-4324-BF43-A2E8-7E0A1EDB8AB2}" srcId="{22D785ED-2458-C645-9C88-AEC01571BDB4}" destId="{D1984497-29B1-1044-8DE8-70CA696079F1}" srcOrd="4" destOrd="0" parTransId="{1086CD3A-EF0D-A54F-962F-C03ED22C7E4A}" sibTransId="{5A950B5D-8930-084A-995B-1A5BF7E5CFE4}"/>
    <dgm:cxn modelId="{C87CECCA-38ED-C14E-B3F4-65436AAE6065}" type="presOf" srcId="{EC2874FC-CD24-FB44-A965-D0F87D1E54EB}" destId="{2B80C3A1-24DB-5545-AA64-14D53FB503FE}" srcOrd="0" destOrd="0" presId="urn:microsoft.com/office/officeart/2005/8/layout/process4"/>
    <dgm:cxn modelId="{62EA27E7-2BC4-C94A-A44E-2563ACF8E164}" type="presOf" srcId="{22D785ED-2458-C645-9C88-AEC01571BDB4}" destId="{5271C860-0FEC-CA47-9DF1-EF4DE2253301}" srcOrd="0" destOrd="0" presId="urn:microsoft.com/office/officeart/2005/8/layout/process4"/>
    <dgm:cxn modelId="{1917B173-EF17-E840-8A02-37EE860CB1CB}" type="presParOf" srcId="{5271C860-0FEC-CA47-9DF1-EF4DE2253301}" destId="{7868ABE0-931E-8A4D-8856-875F3A2FFEF5}" srcOrd="0" destOrd="0" presId="urn:microsoft.com/office/officeart/2005/8/layout/process4"/>
    <dgm:cxn modelId="{4F51DF00-A126-2845-8182-439F90BF5A7D}" type="presParOf" srcId="{7868ABE0-931E-8A4D-8856-875F3A2FFEF5}" destId="{6CCDF85D-8B2C-8044-BBAA-824965846F17}" srcOrd="0" destOrd="0" presId="urn:microsoft.com/office/officeart/2005/8/layout/process4"/>
    <dgm:cxn modelId="{FFC964B0-0989-624C-9D3C-7F070F121DFF}" type="presParOf" srcId="{5271C860-0FEC-CA47-9DF1-EF4DE2253301}" destId="{78CB3A80-F8DE-9240-B056-A34BB9D3F442}" srcOrd="1" destOrd="0" presId="urn:microsoft.com/office/officeart/2005/8/layout/process4"/>
    <dgm:cxn modelId="{977CF69A-09B3-4E47-B55A-7F33B60A6952}" type="presParOf" srcId="{5271C860-0FEC-CA47-9DF1-EF4DE2253301}" destId="{0A28C592-CB4A-0B44-A06A-0B564A25C534}" srcOrd="2" destOrd="0" presId="urn:microsoft.com/office/officeart/2005/8/layout/process4"/>
    <dgm:cxn modelId="{2573806A-6506-534E-8439-04A59101491B}" type="presParOf" srcId="{0A28C592-CB4A-0B44-A06A-0B564A25C534}" destId="{2B80C3A1-24DB-5545-AA64-14D53FB503FE}" srcOrd="0" destOrd="0" presId="urn:microsoft.com/office/officeart/2005/8/layout/process4"/>
    <dgm:cxn modelId="{99F7039B-62C0-3145-AF2C-19AEB0F48696}" type="presParOf" srcId="{5271C860-0FEC-CA47-9DF1-EF4DE2253301}" destId="{A451EBAA-0D78-7D48-BF71-A0DF54BB0863}" srcOrd="3" destOrd="0" presId="urn:microsoft.com/office/officeart/2005/8/layout/process4"/>
    <dgm:cxn modelId="{BEB876B1-E004-A84C-B270-806DE4C5AF43}" type="presParOf" srcId="{5271C860-0FEC-CA47-9DF1-EF4DE2253301}" destId="{EB9ED6DD-FFD7-4945-BE25-E36CC148017B}" srcOrd="4" destOrd="0" presId="urn:microsoft.com/office/officeart/2005/8/layout/process4"/>
    <dgm:cxn modelId="{DBC486C8-18FC-F94D-9A55-67E9F4B253C5}" type="presParOf" srcId="{EB9ED6DD-FFD7-4945-BE25-E36CC148017B}" destId="{6F065D3D-85A0-6542-8141-D9721674AD75}" srcOrd="0" destOrd="0" presId="urn:microsoft.com/office/officeart/2005/8/layout/process4"/>
    <dgm:cxn modelId="{216FB14A-1BF5-A446-92F9-A5D2F4AB0F25}" type="presParOf" srcId="{5271C860-0FEC-CA47-9DF1-EF4DE2253301}" destId="{1B120042-B04E-F848-888A-819DE310FAD5}" srcOrd="5" destOrd="0" presId="urn:microsoft.com/office/officeart/2005/8/layout/process4"/>
    <dgm:cxn modelId="{9C4ACB7A-3C4F-AA4B-BDBE-4755E018298D}" type="presParOf" srcId="{5271C860-0FEC-CA47-9DF1-EF4DE2253301}" destId="{C27FD0DE-7753-B24C-BF73-665111039FA1}" srcOrd="6" destOrd="0" presId="urn:microsoft.com/office/officeart/2005/8/layout/process4"/>
    <dgm:cxn modelId="{67A17C60-6F3C-0B4B-851D-06C3144C3D8B}" type="presParOf" srcId="{C27FD0DE-7753-B24C-BF73-665111039FA1}" destId="{06ECA7A6-D276-8B41-BB68-0CDC838D6D31}" srcOrd="0" destOrd="0" presId="urn:microsoft.com/office/officeart/2005/8/layout/process4"/>
    <dgm:cxn modelId="{C8E92A4D-D478-124D-BF21-526FE2CA6940}" type="presParOf" srcId="{5271C860-0FEC-CA47-9DF1-EF4DE2253301}" destId="{AB7AA94D-3D52-B640-B79A-183EC311D9E8}" srcOrd="7" destOrd="0" presId="urn:microsoft.com/office/officeart/2005/8/layout/process4"/>
    <dgm:cxn modelId="{F001DBA6-2107-B241-8865-CD179004C132}" type="presParOf" srcId="{5271C860-0FEC-CA47-9DF1-EF4DE2253301}" destId="{1AE1985C-2EB9-3041-87F5-531D2324CB46}" srcOrd="8" destOrd="0" presId="urn:microsoft.com/office/officeart/2005/8/layout/process4"/>
    <dgm:cxn modelId="{7B303E00-7F0F-BE49-A65D-E656F2B1B0CF}" type="presParOf" srcId="{1AE1985C-2EB9-3041-87F5-531D2324CB46}" destId="{F7F1675C-641E-654C-9FD9-CC54C676BCC8}" srcOrd="0" destOrd="0" presId="urn:microsoft.com/office/officeart/2005/8/layout/process4"/>
    <dgm:cxn modelId="{3F21D701-F612-2446-A6F8-9712CDC2FEAF}" type="presParOf" srcId="{5271C860-0FEC-CA47-9DF1-EF4DE2253301}" destId="{B02069EA-A275-F643-AB0E-9542A8F5AD00}" srcOrd="9" destOrd="0" presId="urn:microsoft.com/office/officeart/2005/8/layout/process4"/>
    <dgm:cxn modelId="{1CEB502A-7045-E94F-9E5F-B5F9AA12F0B1}" type="presParOf" srcId="{5271C860-0FEC-CA47-9DF1-EF4DE2253301}" destId="{6B63C600-E196-9545-89CC-67A25E2D0AB5}" srcOrd="10" destOrd="0" presId="urn:microsoft.com/office/officeart/2005/8/layout/process4"/>
    <dgm:cxn modelId="{602BABD0-DEDF-5446-81E8-A1CB920A055C}" type="presParOf" srcId="{6B63C600-E196-9545-89CC-67A25E2D0AB5}" destId="{100D4726-FE18-1642-BA58-2471DB0A197F}" srcOrd="0" destOrd="0" presId="urn:microsoft.com/office/officeart/2005/8/layout/process4"/>
    <dgm:cxn modelId="{FFB9ABA0-D8F0-F349-B036-5B82F82FE0C9}" type="presParOf" srcId="{5271C860-0FEC-CA47-9DF1-EF4DE2253301}" destId="{21190727-1C8E-6344-989E-18E5785F3097}" srcOrd="11" destOrd="0" presId="urn:microsoft.com/office/officeart/2005/8/layout/process4"/>
    <dgm:cxn modelId="{3FDC9613-8C45-924C-AC77-43448654E704}" type="presParOf" srcId="{5271C860-0FEC-CA47-9DF1-EF4DE2253301}" destId="{9D5EA433-AAC3-1B49-B95C-01EBA21FC126}" srcOrd="12" destOrd="0" presId="urn:microsoft.com/office/officeart/2005/8/layout/process4"/>
    <dgm:cxn modelId="{7CBD335A-6378-BB4E-A01D-9503DBDCE5DA}" type="presParOf" srcId="{9D5EA433-AAC3-1B49-B95C-01EBA21FC126}" destId="{614BB742-D0A2-2D44-B25E-019A363908CD}" srcOrd="0" destOrd="0" presId="urn:microsoft.com/office/officeart/2005/8/layout/process4"/>
  </dgm:cxnLst>
  <dgm:bg>
    <a:noFill/>
  </dgm:bg>
  <dgm:whole>
    <a:ln>
      <a:noFill/>
    </a:ln>
  </dgm:whole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CDF85D-8B2C-8044-BBAA-824965846F17}">
      <dsp:nvSpPr>
        <dsp:cNvPr id="0" name=""/>
        <dsp:cNvSpPr/>
      </dsp:nvSpPr>
      <dsp:spPr>
        <a:xfrm>
          <a:off x="0" y="5188296"/>
          <a:ext cx="6635262" cy="567752"/>
        </a:xfrm>
        <a:prstGeom prst="rect">
          <a:avLst/>
        </a:prstGeom>
        <a:gradFill rotWithShape="0">
          <a:gsLst>
            <a:gs pos="0">
              <a:schemeClr val="accent4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113792" tIns="113792" rIns="113792" bIns="113792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Population genetics and statistical analyses </a:t>
          </a:r>
        </a:p>
      </dsp:txBody>
      <dsp:txXfrm>
        <a:off x="0" y="5188296"/>
        <a:ext cx="6635262" cy="567752"/>
      </dsp:txXfrm>
    </dsp:sp>
    <dsp:sp modelId="{2B80C3A1-24DB-5545-AA64-14D53FB503FE}">
      <dsp:nvSpPr>
        <dsp:cNvPr id="0" name=""/>
        <dsp:cNvSpPr/>
      </dsp:nvSpPr>
      <dsp:spPr>
        <a:xfrm rot="10800000">
          <a:off x="0" y="4323609"/>
          <a:ext cx="6635262" cy="873203"/>
        </a:xfrm>
        <a:prstGeom prst="upArrowCallout">
          <a:avLst/>
        </a:prstGeom>
        <a:gradFill rotWithShape="0">
          <a:gsLst>
            <a:gs pos="0">
              <a:schemeClr val="accent4">
                <a:hueOff val="1633482"/>
                <a:satOff val="-6796"/>
                <a:lumOff val="1601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1633482"/>
                <a:satOff val="-6796"/>
                <a:lumOff val="1601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1633482"/>
                <a:satOff val="-6796"/>
                <a:lumOff val="1601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113792" tIns="113792" rIns="113792" bIns="113792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SNP filtering using </a:t>
          </a:r>
          <a:r>
            <a:rPr lang="en-US" sz="1600" b="0" i="1" kern="1200" dirty="0" err="1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vcftools</a:t>
          </a:r>
          <a:endParaRPr lang="en-US" sz="1600" b="0" i="1" kern="1200" dirty="0">
            <a:ln/>
            <a:latin typeface="Arial" panose="020B0604020202020204" pitchFamily="34" charset="0"/>
            <a:ea typeface="+mn-ea"/>
            <a:cs typeface="Arial" panose="020B0604020202020204" pitchFamily="34" charset="0"/>
          </a:endParaRPr>
        </a:p>
      </dsp:txBody>
      <dsp:txXfrm rot="10800000">
        <a:off x="0" y="4323609"/>
        <a:ext cx="6635262" cy="567381"/>
      </dsp:txXfrm>
    </dsp:sp>
    <dsp:sp modelId="{6F065D3D-85A0-6542-8141-D9721674AD75}">
      <dsp:nvSpPr>
        <dsp:cNvPr id="0" name=""/>
        <dsp:cNvSpPr/>
      </dsp:nvSpPr>
      <dsp:spPr>
        <a:xfrm rot="10800000">
          <a:off x="0" y="3458922"/>
          <a:ext cx="6635262" cy="873203"/>
        </a:xfrm>
        <a:prstGeom prst="upArrowCallout">
          <a:avLst/>
        </a:prstGeom>
        <a:gradFill rotWithShape="0">
          <a:gsLst>
            <a:gs pos="0">
              <a:schemeClr val="accent4">
                <a:hueOff val="3266964"/>
                <a:satOff val="-13592"/>
                <a:lumOff val="3203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3266964"/>
                <a:satOff val="-13592"/>
                <a:lumOff val="3203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3266964"/>
                <a:satOff val="-13592"/>
                <a:lumOff val="3203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113792" tIns="113792" rIns="113792" bIns="113792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0" i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SNP calling using samtools </a:t>
          </a:r>
          <a:r>
            <a:rPr lang="en-US" sz="1600" b="0" i="1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mpileup</a:t>
          </a:r>
        </a:p>
      </dsp:txBody>
      <dsp:txXfrm rot="10800000">
        <a:off x="0" y="3458922"/>
        <a:ext cx="6635262" cy="567381"/>
      </dsp:txXfrm>
    </dsp:sp>
    <dsp:sp modelId="{06ECA7A6-D276-8B41-BB68-0CDC838D6D31}">
      <dsp:nvSpPr>
        <dsp:cNvPr id="0" name=""/>
        <dsp:cNvSpPr/>
      </dsp:nvSpPr>
      <dsp:spPr>
        <a:xfrm rot="10800000">
          <a:off x="0" y="2594235"/>
          <a:ext cx="6635262" cy="873203"/>
        </a:xfrm>
        <a:prstGeom prst="upArrowCallout">
          <a:avLst/>
        </a:prstGeom>
        <a:gradFill rotWithShape="0">
          <a:gsLst>
            <a:gs pos="0">
              <a:schemeClr val="accent4">
                <a:hueOff val="4900445"/>
                <a:satOff val="-20388"/>
                <a:lumOff val="4804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4900445"/>
                <a:satOff val="-20388"/>
                <a:lumOff val="4804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4900445"/>
                <a:satOff val="-20388"/>
                <a:lumOff val="4804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113792" tIns="113792" rIns="113792" bIns="113792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Collect summary statistics using </a:t>
          </a:r>
          <a:r>
            <a:rPr lang="en-US" sz="1600" b="0" i="1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qualimap</a:t>
          </a:r>
        </a:p>
      </dsp:txBody>
      <dsp:txXfrm rot="10800000">
        <a:off x="0" y="2594235"/>
        <a:ext cx="6635262" cy="567381"/>
      </dsp:txXfrm>
    </dsp:sp>
    <dsp:sp modelId="{F7F1675C-641E-654C-9FD9-CC54C676BCC8}">
      <dsp:nvSpPr>
        <dsp:cNvPr id="0" name=""/>
        <dsp:cNvSpPr/>
      </dsp:nvSpPr>
      <dsp:spPr>
        <a:xfrm rot="10800000">
          <a:off x="0" y="1729548"/>
          <a:ext cx="6635262" cy="873203"/>
        </a:xfrm>
        <a:prstGeom prst="upArrowCallout">
          <a:avLst/>
        </a:prstGeom>
        <a:gradFill rotWithShape="0">
          <a:gsLst>
            <a:gs pos="0">
              <a:schemeClr val="accent4">
                <a:hueOff val="6533927"/>
                <a:satOff val="-27185"/>
                <a:lumOff val="6405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6533927"/>
                <a:satOff val="-27185"/>
                <a:lumOff val="6405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6533927"/>
                <a:satOff val="-27185"/>
                <a:lumOff val="6405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113792" tIns="113792" rIns="113792" bIns="113792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Mapping/Aligning  to reference sequence using </a:t>
          </a:r>
          <a:r>
            <a:rPr lang="en-US" sz="1600" b="0" i="1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bwa-mem</a:t>
          </a:r>
        </a:p>
      </dsp:txBody>
      <dsp:txXfrm rot="10800000">
        <a:off x="0" y="1729548"/>
        <a:ext cx="6635262" cy="567381"/>
      </dsp:txXfrm>
    </dsp:sp>
    <dsp:sp modelId="{100D4726-FE18-1642-BA58-2471DB0A197F}">
      <dsp:nvSpPr>
        <dsp:cNvPr id="0" name=""/>
        <dsp:cNvSpPr/>
      </dsp:nvSpPr>
      <dsp:spPr>
        <a:xfrm rot="10800000">
          <a:off x="0" y="864861"/>
          <a:ext cx="6635262" cy="873203"/>
        </a:xfrm>
        <a:prstGeom prst="upArrowCallout">
          <a:avLst/>
        </a:prstGeom>
        <a:gradFill rotWithShape="0">
          <a:gsLst>
            <a:gs pos="0">
              <a:schemeClr val="accent4">
                <a:hueOff val="8167408"/>
                <a:satOff val="-33981"/>
                <a:lumOff val="8007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8167408"/>
                <a:satOff val="-33981"/>
                <a:lumOff val="8007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8167408"/>
                <a:satOff val="-33981"/>
                <a:lumOff val="8007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113792" tIns="113792" rIns="113792" bIns="113792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Quality checking using </a:t>
          </a:r>
          <a:r>
            <a:rPr lang="en-US" sz="1600" b="0" i="1" kern="1200" dirty="0" err="1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Fastqc</a:t>
          </a:r>
          <a:r>
            <a:rPr lang="en-US" sz="1600" b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  and trimming using Trimmomatic</a:t>
          </a:r>
          <a:endParaRPr lang="en-US" sz="1600" kern="1200" dirty="0">
            <a:ln/>
            <a:latin typeface="Arial" panose="020B0604020202020204" pitchFamily="34" charset="0"/>
            <a:ea typeface="+mn-ea"/>
            <a:cs typeface="Arial" panose="020B0604020202020204" pitchFamily="34" charset="0"/>
          </a:endParaRPr>
        </a:p>
      </dsp:txBody>
      <dsp:txXfrm rot="10800000">
        <a:off x="0" y="864861"/>
        <a:ext cx="6635262" cy="567381"/>
      </dsp:txXfrm>
    </dsp:sp>
    <dsp:sp modelId="{614BB742-D0A2-2D44-B25E-019A363908CD}">
      <dsp:nvSpPr>
        <dsp:cNvPr id="0" name=""/>
        <dsp:cNvSpPr/>
      </dsp:nvSpPr>
      <dsp:spPr>
        <a:xfrm rot="10800000">
          <a:off x="0" y="0"/>
          <a:ext cx="6635262" cy="873203"/>
        </a:xfrm>
        <a:prstGeom prst="upArrowCallout">
          <a:avLst/>
        </a:prstGeom>
        <a:gradFill rotWithShape="0">
          <a:gsLst>
            <a:gs pos="0">
              <a:schemeClr val="accent4">
                <a:hueOff val="9800891"/>
                <a:satOff val="-40777"/>
                <a:lumOff val="9608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4">
                <a:hueOff val="9800891"/>
                <a:satOff val="-40777"/>
                <a:lumOff val="9608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4">
                <a:hueOff val="9800891"/>
                <a:satOff val="-40777"/>
                <a:lumOff val="9608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113792" tIns="113792" rIns="113792" bIns="113792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b="0" kern="1200" dirty="0">
              <a:ln/>
              <a:latin typeface="Arial" panose="020B0604020202020204" pitchFamily="34" charset="0"/>
              <a:ea typeface="+mn-ea"/>
              <a:cs typeface="Arial" panose="020B0604020202020204" pitchFamily="34" charset="0"/>
            </a:rPr>
            <a:t>Demultiplexing samples based on Index</a:t>
          </a:r>
        </a:p>
      </dsp:txBody>
      <dsp:txXfrm rot="10800000">
        <a:off x="0" y="0"/>
        <a:ext cx="6635262" cy="56738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A3512-7940-0048-A3D7-7D97BDB426A7}" type="datetimeFigureOut">
              <a:rPr lang="en-US" smtClean="0"/>
              <a:t>4/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861141-02F1-A849-A4A1-CBF1ED6B7F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6768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AU" sz="1200" b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6807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7611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5772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b="1" i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b="0" kern="12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endParaRPr lang="en-US" sz="1200" b="0" kern="12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228600" indent="-228600">
              <a:buAutoNum type="alphaUcParenR"/>
            </a:pPr>
            <a:endParaRPr lang="en-US" sz="1200" b="0" kern="12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endParaRPr lang="en-US" b="1" i="0" dirty="0"/>
          </a:p>
          <a:p>
            <a:endParaRPr lang="en-US" b="1" i="0" dirty="0"/>
          </a:p>
          <a:p>
            <a:endParaRPr lang="en-US" b="1" i="0" dirty="0"/>
          </a:p>
          <a:p>
            <a:endParaRPr lang="en-US" b="1" i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47925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24965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50671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44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95776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829F6-39DE-4349-9C2B-6A967D657EB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7556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91A06-2B9B-164A-890A-3099CB49FA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CE0879-8B8C-234D-8E09-560169BB39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DA18B5-0152-124B-808F-9F7C209BD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D2B469-0674-6342-B4AF-7DB796BC7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DE306A-454C-524F-9D89-C7F6892B8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8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F5EF16-D664-1844-A0E7-A48A77323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597607-3FBE-9D42-91EC-86763F6DC7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CD5C50-4A67-524A-B088-9ECD068AD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3DE4CA-7DD8-704A-9192-2E810EE70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59EBFA-FE28-BD46-B542-0F0EAEF33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699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F40AA5-85AE-9340-9E5D-593FA10C80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BB852D-09F0-DF4E-99CF-BA5A4C9C54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94F43-63C9-AC42-8271-30C4B1C3A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71029-28E0-E34A-9A89-E191957F1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C81D-B2C4-9845-993C-D4384ED6E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181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F8E5A-9739-1B4C-825B-635271CD5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4B8F7-B51A-B740-A34C-1AC1764920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10C322-D2AB-E34B-B6CA-D7A1A48F5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27883A-12A2-1E41-86E2-D8E7424D5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A19AD-5A84-D64B-9EF5-3EF931623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85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D481CE-5255-504C-9AE6-8017AF5674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271F88-5043-E24B-9778-7E49C1CAC6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AEBC2-711B-944D-A67C-0D28408EA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7D8D90-0F34-5143-9964-27D827433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61A42B-A86D-B047-89C9-20CBEB8C1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479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7E8D8-DAB9-3B40-A2F9-48199CE931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914580-B860-CE4C-889E-F905765B5F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09900D-0A38-EE4D-9202-3989667FDA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E9DF1D-809E-3548-A32C-BF4D931DA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4F3528-784A-1245-9503-B3624561E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236A0D-5779-7E4D-BB1A-A0386F497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812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1D8AAA-E6E4-DE4C-B952-501553DC7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6AA166-09F4-2646-A9BB-54CD85FBAA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FA314F-5A12-D043-AAD3-A73279F3D8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273B7C-6D29-C84A-933D-4F8FBE5553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1E6121F-A903-9349-B7AF-C720B4DB89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4986A7C-2969-0B4A-84AE-E7BA22CEA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B60091D-8A19-5140-94F6-53AF111CA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5AAF30-E2EA-D247-82E8-1F2B38BFC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920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38833F-02DB-3540-8690-57B558489A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553EB49-B4D6-CF42-A2E6-353BDC423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926804-578B-1447-8DC4-8E32CFAC8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3C043D-2470-3F49-9ED6-8CA401015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851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A6F2383-CF19-0643-97B9-379F31685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2789A5-D0FF-D149-B210-80FCEF8EF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3932A4-09C7-B948-90C5-7B3B6BD75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30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89D67-66FB-7844-B0E6-B1D1E2F26C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11D9FC-BB7A-DF4F-917B-9049135377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00FDF8-1F15-2F4E-B7CC-621385787D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32C2D8-A2B9-D74D-A786-0CB847B14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5FC957-2EE0-E443-A224-E534848E7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3DAF53-39F0-3D45-A029-DB4040BBA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146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A4762C-96D2-6148-A6C2-AB3009F520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4307CE-D82D-6C4E-BEA4-E15C7B8B08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DCC17B-9BAF-0247-9DC9-F3BB2B6D06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B609A6-0DDC-1C4F-AFE0-226B1D12D8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A0F1A-408D-2E4E-A5C9-166365614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C410A5-06E1-C144-A974-E99C1F211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326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D03F63-B162-1E44-8EA0-A40AB40E5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853542-AAA1-CA42-BBE3-6CAE422F8C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E36A01-3574-534D-B454-5A85238137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E70D8-38CA-E047-A703-BB81B3FA88F9}" type="datetimeFigureOut">
              <a:rPr lang="en-US" smtClean="0"/>
              <a:t>4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058FBC-6D8E-5E4F-A927-C1A72A78FB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81956E-0D79-9D4F-BBBF-692430D6A5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EA001-F4E5-9B4E-A438-53E728010A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850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chart" Target="../charts/chart1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file:////var/folders/pp/10_28st534jf84mwmgy6dyxw0002h3/T/com.microsoft.Word/WebArchiveCopyPasteTempFiles/plot.png%3fwidth=764&amp;height=511&amp;randomizer=1261472088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6B124538-99E9-1B4F-8FA3-D2CC2B361E4D}"/>
              </a:ext>
            </a:extLst>
          </p:cNvPr>
          <p:cNvGrpSpPr/>
          <p:nvPr/>
        </p:nvGrpSpPr>
        <p:grpSpPr>
          <a:xfrm>
            <a:off x="1218399" y="360417"/>
            <a:ext cx="9721962" cy="6383278"/>
            <a:chOff x="1218399" y="360417"/>
            <a:chExt cx="9721962" cy="638327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4C57E62-0B56-154B-A7D6-A895CBB37236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18399" y="459666"/>
              <a:ext cx="9662983" cy="5563998"/>
            </a:xfrm>
            <a:prstGeom prst="rect">
              <a:avLst/>
            </a:prstGeom>
            <a:noFill/>
            <a:ln>
              <a:noFill/>
            </a:ln>
            <a:effectLst>
              <a:outerShdw dist="1625600" dir="14100000" sx="1000" sy="1000" algn="ctr" rotWithShape="0">
                <a:srgbClr val="000000">
                  <a:alpha val="87999"/>
                </a:srgbClr>
              </a:outerShdw>
            </a:effectLst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346F5890-EF8D-124D-945F-7ECD3BFE3B37}"/>
                </a:ext>
              </a:extLst>
            </p:cNvPr>
            <p:cNvSpPr/>
            <p:nvPr/>
          </p:nvSpPr>
          <p:spPr>
            <a:xfrm>
              <a:off x="4684643" y="1749287"/>
              <a:ext cx="490331" cy="3048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26E143D4-6D2E-D44F-828C-7EDF530F38A0}"/>
                </a:ext>
              </a:extLst>
            </p:cNvPr>
            <p:cNvGrpSpPr/>
            <p:nvPr/>
          </p:nvGrpSpPr>
          <p:grpSpPr>
            <a:xfrm>
              <a:off x="3011218" y="2065061"/>
              <a:ext cx="5174050" cy="4678634"/>
              <a:chOff x="3538990" y="1902800"/>
              <a:chExt cx="3583335" cy="3847571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1B017721-482A-7D4C-BEE0-090BBE61EDC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538994" y="1902800"/>
                <a:ext cx="3583331" cy="990538"/>
                <a:chOff x="5844242" y="1930410"/>
                <a:chExt cx="2959254" cy="630006"/>
              </a:xfrm>
            </p:grpSpPr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4B3E98AD-8056-1241-929C-9F55914CE956}"/>
                    </a:ext>
                  </a:extLst>
                </p:cNvPr>
                <p:cNvSpPr/>
                <p:nvPr/>
              </p:nvSpPr>
              <p:spPr>
                <a:xfrm>
                  <a:off x="5844242" y="1930410"/>
                  <a:ext cx="2614832" cy="630006"/>
                </a:xfrm>
                <a:prstGeom prst="rect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b="1" dirty="0"/>
                </a:p>
              </p:txBody>
            </p:sp>
            <p:sp>
              <p:nvSpPr>
                <p:cNvPr id="28" name="Trapezoid 27">
                  <a:extLst>
                    <a:ext uri="{FF2B5EF4-FFF2-40B4-BE49-F238E27FC236}">
                      <a16:creationId xmlns:a16="http://schemas.microsoft.com/office/drawing/2014/main" id="{F3AF5ED5-B398-D84D-877C-7ED9AE4B344A}"/>
                    </a:ext>
                  </a:extLst>
                </p:cNvPr>
                <p:cNvSpPr/>
                <p:nvPr/>
              </p:nvSpPr>
              <p:spPr>
                <a:xfrm rot="10800000">
                  <a:off x="5933120" y="1943109"/>
                  <a:ext cx="1649064" cy="563205"/>
                </a:xfrm>
                <a:prstGeom prst="trapezoid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/>
                </a:p>
              </p:txBody>
            </p:sp>
            <p:sp>
              <p:nvSpPr>
                <p:cNvPr id="29" name="TextBox 37">
                  <a:extLst>
                    <a:ext uri="{FF2B5EF4-FFF2-40B4-BE49-F238E27FC236}">
                      <a16:creationId xmlns:a16="http://schemas.microsoft.com/office/drawing/2014/main" id="{86A7698A-859E-F749-8F4E-7A16136E517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486579" y="2150334"/>
                  <a:ext cx="595203" cy="20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algn="ctr" eaLnBrk="1" hangingPunct="1"/>
                  <a:r>
                    <a:rPr lang="en-US" dirty="0"/>
                    <a:t>405825</a:t>
                  </a:r>
                </a:p>
              </p:txBody>
            </p:sp>
            <p:sp>
              <p:nvSpPr>
                <p:cNvPr id="30" name="TextBox 38">
                  <a:extLst>
                    <a:ext uri="{FF2B5EF4-FFF2-40B4-BE49-F238E27FC236}">
                      <a16:creationId xmlns:a16="http://schemas.microsoft.com/office/drawing/2014/main" id="{51127A2C-CA98-344B-937C-07EED3B319C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489244" y="2114180"/>
                  <a:ext cx="1314252" cy="17708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altLang="en-US" sz="1600" dirty="0">
                      <a:ea typeface="ＭＳ Ｐゴシック" charset="-128"/>
                      <a:cs typeface="ＭＳ Ｐゴシック" charset="-128"/>
                    </a:rPr>
                    <a:t> All variants</a:t>
                  </a:r>
                  <a:endParaRPr lang="en-US" altLang="en-US" sz="1600" baseline="30000" dirty="0">
                    <a:ea typeface="ＭＳ Ｐゴシック" charset="-128"/>
                    <a:cs typeface="ＭＳ Ｐゴシック" charset="-128"/>
                  </a:endParaRPr>
                </a:p>
              </p:txBody>
            </p:sp>
          </p:grpSp>
          <p:grpSp>
            <p:nvGrpSpPr>
              <p:cNvPr id="7" name="Group 50180">
                <a:extLst>
                  <a:ext uri="{FF2B5EF4-FFF2-40B4-BE49-F238E27FC236}">
                    <a16:creationId xmlns:a16="http://schemas.microsoft.com/office/drawing/2014/main" id="{EA9A7047-52D0-9242-BD3B-7317B2B61378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538990" y="2797555"/>
                <a:ext cx="3341801" cy="793952"/>
                <a:chOff x="5843179" y="2642257"/>
                <a:chExt cx="2760700" cy="596227"/>
              </a:xfrm>
            </p:grpSpPr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CAC3A576-98A5-4D47-9461-28F93AC95E06}"/>
                    </a:ext>
                  </a:extLst>
                </p:cNvPr>
                <p:cNvSpPr/>
                <p:nvPr/>
              </p:nvSpPr>
              <p:spPr>
                <a:xfrm>
                  <a:off x="5843179" y="2682148"/>
                  <a:ext cx="2615695" cy="556336"/>
                </a:xfrm>
                <a:prstGeom prst="rect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b="1" dirty="0"/>
                </a:p>
              </p:txBody>
            </p:sp>
            <p:sp>
              <p:nvSpPr>
                <p:cNvPr id="24" name="Trapezoid 23">
                  <a:extLst>
                    <a:ext uri="{FF2B5EF4-FFF2-40B4-BE49-F238E27FC236}">
                      <a16:creationId xmlns:a16="http://schemas.microsoft.com/office/drawing/2014/main" id="{2815C544-9F4D-0E4F-BC6B-1407D8F9E08A}"/>
                    </a:ext>
                  </a:extLst>
                </p:cNvPr>
                <p:cNvSpPr/>
                <p:nvPr/>
              </p:nvSpPr>
              <p:spPr>
                <a:xfrm rot="10800000">
                  <a:off x="6083553" y="2649482"/>
                  <a:ext cx="1339705" cy="573820"/>
                </a:xfrm>
                <a:prstGeom prst="trapezoid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dirty="0"/>
                </a:p>
              </p:txBody>
            </p:sp>
            <p:sp>
              <p:nvSpPr>
                <p:cNvPr id="25" name="TextBox 36">
                  <a:extLst>
                    <a:ext uri="{FF2B5EF4-FFF2-40B4-BE49-F238E27FC236}">
                      <a16:creationId xmlns:a16="http://schemas.microsoft.com/office/drawing/2014/main" id="{0475244C-0FAF-D344-86E3-A02E58F28D5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01368" y="2793231"/>
                  <a:ext cx="595400" cy="2470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algn="ctr" eaLnBrk="1" hangingPunct="1"/>
                  <a:r>
                    <a:rPr lang="uk-UA" altLang="en-US" dirty="0">
                      <a:solidFill>
                        <a:schemeClr val="bg1"/>
                      </a:solidFill>
                      <a:ea typeface="ＭＳ Ｐゴシック" charset="-128"/>
                      <a:cs typeface="ＭＳ Ｐゴシック" charset="-128"/>
                    </a:rPr>
                    <a:t>144517</a:t>
                  </a:r>
                  <a:endParaRPr lang="en-US" dirty="0"/>
                </a:p>
              </p:txBody>
            </p:sp>
            <p:sp>
              <p:nvSpPr>
                <p:cNvPr id="26" name="TextBox 39">
                  <a:extLst>
                    <a:ext uri="{FF2B5EF4-FFF2-40B4-BE49-F238E27FC236}">
                      <a16:creationId xmlns:a16="http://schemas.microsoft.com/office/drawing/2014/main" id="{B4036982-C040-FC4A-B30F-F2BA21D3A8D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436695" y="2642257"/>
                  <a:ext cx="1167184" cy="4959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en-US" sz="1600" dirty="0"/>
                    <a:t>Excluded hypervariable regions </a:t>
                  </a:r>
                  <a:endParaRPr lang="en-US" sz="1600" baseline="30000" dirty="0"/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914D1E14-EBAD-2A40-B530-787D8784EF41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538992" y="3554985"/>
                <a:ext cx="3166274" cy="716919"/>
                <a:chOff x="5843181" y="3304311"/>
                <a:chExt cx="2615692" cy="536975"/>
              </a:xfrm>
            </p:grpSpPr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08D350DB-C170-1044-9762-EB2FBEBD2CA3}"/>
                    </a:ext>
                  </a:extLst>
                </p:cNvPr>
                <p:cNvSpPr/>
                <p:nvPr/>
              </p:nvSpPr>
              <p:spPr>
                <a:xfrm>
                  <a:off x="5843181" y="3304311"/>
                  <a:ext cx="2615692" cy="531106"/>
                </a:xfrm>
                <a:prstGeom prst="rect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b="1" dirty="0"/>
                </a:p>
              </p:txBody>
            </p:sp>
            <p:sp>
              <p:nvSpPr>
                <p:cNvPr id="20" name="Trapezoid 19">
                  <a:extLst>
                    <a:ext uri="{FF2B5EF4-FFF2-40B4-BE49-F238E27FC236}">
                      <a16:creationId xmlns:a16="http://schemas.microsoft.com/office/drawing/2014/main" id="{AC389646-9B9F-0648-83A1-D56EAE1C22C8}"/>
                    </a:ext>
                  </a:extLst>
                </p:cNvPr>
                <p:cNvSpPr/>
                <p:nvPr/>
              </p:nvSpPr>
              <p:spPr>
                <a:xfrm rot="10800000">
                  <a:off x="6205728" y="3305566"/>
                  <a:ext cx="1087994" cy="535720"/>
                </a:xfrm>
                <a:prstGeom prst="trapezoid">
                  <a:avLst/>
                </a:prstGeom>
                <a:solidFill>
                  <a:srgbClr val="FFC000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dirty="0"/>
                </a:p>
              </p:txBody>
            </p:sp>
            <p:sp>
              <p:nvSpPr>
                <p:cNvPr id="21" name="TextBox 43">
                  <a:extLst>
                    <a:ext uri="{FF2B5EF4-FFF2-40B4-BE49-F238E27FC236}">
                      <a16:creationId xmlns:a16="http://schemas.microsoft.com/office/drawing/2014/main" id="{3CCB0327-ED23-A642-9D21-3A093B11971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58848" y="3494255"/>
                  <a:ext cx="1250514" cy="2535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algn="ctr" eaLnBrk="1" hangingPunct="1"/>
                  <a:r>
                    <a:rPr lang="en-US" sz="1600" dirty="0"/>
                    <a:t>MAF &gt; 10%</a:t>
                  </a:r>
                  <a:endParaRPr lang="en-US" sz="1600" baseline="30000" dirty="0"/>
                </a:p>
              </p:txBody>
            </p:sp>
            <p:sp>
              <p:nvSpPr>
                <p:cNvPr id="22" name="TextBox 46">
                  <a:extLst>
                    <a:ext uri="{FF2B5EF4-FFF2-40B4-BE49-F238E27FC236}">
                      <a16:creationId xmlns:a16="http://schemas.microsoft.com/office/drawing/2014/main" id="{A608B78A-DCE2-FB4E-A30A-AA59C3C34EB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418877" y="3390131"/>
                  <a:ext cx="673581" cy="2996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algn="ctr" eaLnBrk="1" hangingPunct="1"/>
                  <a:r>
                    <a:rPr lang="en-US" b="1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4283</a:t>
                  </a:r>
                </a:p>
              </p:txBody>
            </p: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82E23B31-0480-7A47-A33F-3EFA3F5DCFC1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538992" y="4248763"/>
                <a:ext cx="3166274" cy="714896"/>
                <a:chOff x="5843183" y="3875114"/>
                <a:chExt cx="2615694" cy="536908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E13F55C2-CB3B-594F-A665-E992CE895560}"/>
                    </a:ext>
                  </a:extLst>
                </p:cNvPr>
                <p:cNvSpPr/>
                <p:nvPr/>
              </p:nvSpPr>
              <p:spPr>
                <a:xfrm>
                  <a:off x="5843183" y="3875114"/>
                  <a:ext cx="2615694" cy="530952"/>
                </a:xfrm>
                <a:prstGeom prst="rect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b="1" dirty="0"/>
                </a:p>
              </p:txBody>
            </p:sp>
            <p:sp>
              <p:nvSpPr>
                <p:cNvPr id="16" name="Trapezoid 15">
                  <a:extLst>
                    <a:ext uri="{FF2B5EF4-FFF2-40B4-BE49-F238E27FC236}">
                      <a16:creationId xmlns:a16="http://schemas.microsoft.com/office/drawing/2014/main" id="{2CDD0796-0C79-DB40-A49F-2A39B22BE088}"/>
                    </a:ext>
                  </a:extLst>
                </p:cNvPr>
                <p:cNvSpPr/>
                <p:nvPr/>
              </p:nvSpPr>
              <p:spPr>
                <a:xfrm rot="10800000">
                  <a:off x="6322225" y="3876302"/>
                  <a:ext cx="855274" cy="535720"/>
                </a:xfrm>
                <a:prstGeom prst="trapezoid">
                  <a:avLst/>
                </a:prstGeom>
                <a:solidFill>
                  <a:srgbClr val="7030A0"/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dirty="0">
                    <a:solidFill>
                      <a:srgbClr val="FFFFFF"/>
                    </a:solidFill>
                  </a:endParaRPr>
                </a:p>
              </p:txBody>
            </p:sp>
            <p:sp>
              <p:nvSpPr>
                <p:cNvPr id="17" name="TextBox 45">
                  <a:extLst>
                    <a:ext uri="{FF2B5EF4-FFF2-40B4-BE49-F238E27FC236}">
                      <a16:creationId xmlns:a16="http://schemas.microsoft.com/office/drawing/2014/main" id="{D47C484B-8F85-824B-945C-C1018558B09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254158" y="3939792"/>
                  <a:ext cx="955366" cy="4391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r>
                    <a:rPr lang="en-US" altLang="en-US" sz="1600" dirty="0">
                      <a:ea typeface="ＭＳ Ｐゴシック" charset="-128"/>
                      <a:cs typeface="ＭＳ Ｐゴシック" charset="-128"/>
                    </a:rPr>
                    <a:t>No LD </a:t>
                  </a:r>
                </a:p>
                <a:p>
                  <a:r>
                    <a:rPr lang="en-US" altLang="en-US" sz="1600" dirty="0">
                      <a:ea typeface="ＭＳ Ｐゴシック" charset="-128"/>
                      <a:cs typeface="ＭＳ Ｐゴシック" charset="-128"/>
                    </a:rPr>
                    <a:t>Neutral</a:t>
                  </a:r>
                </a:p>
              </p:txBody>
            </p:sp>
            <p:sp>
              <p:nvSpPr>
                <p:cNvPr id="18" name="TextBox 47">
                  <a:extLst>
                    <a:ext uri="{FF2B5EF4-FFF2-40B4-BE49-F238E27FC236}">
                      <a16:creationId xmlns:a16="http://schemas.microsoft.com/office/drawing/2014/main" id="{0445654C-AAE7-F746-A8DD-9B46A35C42B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479597" y="3987031"/>
                  <a:ext cx="552139" cy="3158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algn="ctr" eaLnBrk="1" hangingPunct="1"/>
                  <a:r>
                    <a:rPr lang="en-US" sz="2133" b="1" dirty="0">
                      <a:solidFill>
                        <a:srgbClr val="FFFFFF"/>
                      </a:solidFill>
                      <a:latin typeface="Calibri" charset="0"/>
                      <a:cs typeface="Calibri" charset="0"/>
                    </a:rPr>
                    <a:t>4006</a:t>
                  </a: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AA804FA8-B04D-384E-8A7A-DE12AED7391E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538991" y="4931393"/>
                <a:ext cx="3259069" cy="818978"/>
                <a:chOff x="5885002" y="3862199"/>
                <a:chExt cx="2633458" cy="615075"/>
              </a:xfrm>
            </p:grpSpPr>
            <p:sp>
              <p:nvSpPr>
                <p:cNvPr id="11" name="Rectangle 10">
                  <a:extLst>
                    <a:ext uri="{FF2B5EF4-FFF2-40B4-BE49-F238E27FC236}">
                      <a16:creationId xmlns:a16="http://schemas.microsoft.com/office/drawing/2014/main" id="{86E70C1E-59E7-7D4D-89E5-88CFAC9F81B3}"/>
                    </a:ext>
                  </a:extLst>
                </p:cNvPr>
                <p:cNvSpPr/>
                <p:nvPr/>
              </p:nvSpPr>
              <p:spPr>
                <a:xfrm>
                  <a:off x="5885002" y="3866841"/>
                  <a:ext cx="2558477" cy="610433"/>
                </a:xfrm>
                <a:prstGeom prst="rect">
                  <a:avLst/>
                </a:prstGeom>
                <a:solidFill>
                  <a:schemeClr val="bg2">
                    <a:lumMod val="75000"/>
                  </a:schemeClr>
                </a:solidFill>
                <a:ln>
                  <a:noFill/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b="1" dirty="0"/>
                </a:p>
              </p:txBody>
            </p:sp>
            <p:sp>
              <p:nvSpPr>
                <p:cNvPr id="12" name="Trapezoid 11">
                  <a:extLst>
                    <a:ext uri="{FF2B5EF4-FFF2-40B4-BE49-F238E27FC236}">
                      <a16:creationId xmlns:a16="http://schemas.microsoft.com/office/drawing/2014/main" id="{305A793C-955A-1A40-BE52-6430DB79013A}"/>
                    </a:ext>
                  </a:extLst>
                </p:cNvPr>
                <p:cNvSpPr/>
                <p:nvPr/>
              </p:nvSpPr>
              <p:spPr>
                <a:xfrm rot="10800000">
                  <a:off x="6468842" y="3862199"/>
                  <a:ext cx="605236" cy="605504"/>
                </a:xfrm>
                <a:prstGeom prst="trapezoid">
                  <a:avLst/>
                </a:prstGeom>
                <a:solidFill>
                  <a:srgbClr val="009051"/>
                </a:solidFill>
                <a:ln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endParaRPr lang="en-US" sz="2133" dirty="0">
                    <a:solidFill>
                      <a:srgbClr val="FFFFFF"/>
                    </a:solidFill>
                  </a:endParaRPr>
                </a:p>
              </p:txBody>
            </p:sp>
            <p:sp>
              <p:nvSpPr>
                <p:cNvPr id="13" name="TextBox 45">
                  <a:extLst>
                    <a:ext uri="{FF2B5EF4-FFF2-40B4-BE49-F238E27FC236}">
                      <a16:creationId xmlns:a16="http://schemas.microsoft.com/office/drawing/2014/main" id="{B9A967CA-A1B6-364E-9ADA-CE3ADE98744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075830" y="3998197"/>
                  <a:ext cx="1442630" cy="4391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r>
                    <a:rPr lang="en-US" altLang="en-US" sz="1600" dirty="0">
                      <a:ea typeface="ＭＳ Ｐゴシック" charset="-128"/>
                      <a:cs typeface="ＭＳ Ｐゴシック" charset="-128"/>
                    </a:rPr>
                    <a:t>Selected for assay development </a:t>
                  </a:r>
                </a:p>
              </p:txBody>
            </p:sp>
            <p:sp>
              <p:nvSpPr>
                <p:cNvPr id="14" name="TextBox 47">
                  <a:extLst>
                    <a:ext uri="{FF2B5EF4-FFF2-40B4-BE49-F238E27FC236}">
                      <a16:creationId xmlns:a16="http://schemas.microsoft.com/office/drawing/2014/main" id="{5137400E-9A16-5745-825A-91430C24B0C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570358" y="3994130"/>
                  <a:ext cx="441559" cy="31585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algn="ctr" eaLnBrk="1" hangingPunct="1"/>
                  <a:r>
                    <a:rPr lang="en-US" sz="2133" b="1" dirty="0">
                      <a:solidFill>
                        <a:srgbClr val="FFFFFF"/>
                      </a:solidFill>
                      <a:latin typeface="Calibri" charset="0"/>
                      <a:cs typeface="Calibri" charset="0"/>
                    </a:rPr>
                    <a:t>220</a:t>
                  </a:r>
                </a:p>
              </p:txBody>
            </p:sp>
          </p:grpSp>
        </p:grpSp>
        <p:sp>
          <p:nvSpPr>
            <p:cNvPr id="31" name="TextBox 38">
              <a:extLst>
                <a:ext uri="{FF2B5EF4-FFF2-40B4-BE49-F238E27FC236}">
                  <a16:creationId xmlns:a16="http://schemas.microsoft.com/office/drawing/2014/main" id="{897DF806-A9A2-B24F-A5A9-DFFD248A45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29808" y="436324"/>
              <a:ext cx="1423052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en-US" sz="1600" dirty="0">
                  <a:ea typeface="ＭＳ Ｐゴシック" charset="-128"/>
                  <a:cs typeface="ＭＳ Ｐゴシック" charset="-128"/>
                </a:rPr>
                <a:t>Reads</a:t>
              </a:r>
              <a:endParaRPr lang="en-US" altLang="en-US" sz="1600" baseline="30000" dirty="0">
                <a:ea typeface="ＭＳ Ｐゴシック" charset="-128"/>
                <a:cs typeface="ＭＳ Ｐゴシック" charset="-128"/>
              </a:endParaRPr>
            </a:p>
          </p:txBody>
        </p:sp>
        <p:sp>
          <p:nvSpPr>
            <p:cNvPr id="32" name="TextBox 38">
              <a:extLst>
                <a:ext uri="{FF2B5EF4-FFF2-40B4-BE49-F238E27FC236}">
                  <a16:creationId xmlns:a16="http://schemas.microsoft.com/office/drawing/2014/main" id="{01F24AD3-6F7C-4349-BAA3-0339800BB3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25506" y="459666"/>
              <a:ext cx="1423052" cy="350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en-US" sz="1600" dirty="0">
                  <a:ea typeface="ＭＳ Ｐゴシック" charset="-128"/>
                  <a:cs typeface="ＭＳ Ｐゴシック" charset="-128"/>
                </a:rPr>
                <a:t>Sequencing  </a:t>
              </a:r>
              <a:endParaRPr lang="en-US" altLang="en-US" sz="1600" baseline="30000" dirty="0">
                <a:ea typeface="ＭＳ Ｐゴシック" charset="-128"/>
                <a:cs typeface="ＭＳ Ｐゴシック" charset="-128"/>
              </a:endParaRPr>
            </a:p>
          </p:txBody>
        </p:sp>
        <p:sp>
          <p:nvSpPr>
            <p:cNvPr id="33" name="TextBox 38">
              <a:extLst>
                <a:ext uri="{FF2B5EF4-FFF2-40B4-BE49-F238E27FC236}">
                  <a16:creationId xmlns:a16="http://schemas.microsoft.com/office/drawing/2014/main" id="{D30E1C8D-EBF0-DB4C-B98C-20CDD4A57C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01098" y="545318"/>
              <a:ext cx="1423052" cy="350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en-US" sz="1600" dirty="0">
                  <a:ea typeface="ＭＳ Ｐゴシック" charset="-128"/>
                  <a:cs typeface="ＭＳ Ｐゴシック" charset="-128"/>
                </a:rPr>
                <a:t>Samples </a:t>
              </a:r>
              <a:endParaRPr lang="en-US" altLang="en-US" sz="1600" baseline="30000" dirty="0">
                <a:ea typeface="ＭＳ Ｐゴシック" charset="-128"/>
                <a:cs typeface="ＭＳ Ｐゴシック" charset="-128"/>
              </a:endParaRPr>
            </a:p>
          </p:txBody>
        </p:sp>
        <p:sp>
          <p:nvSpPr>
            <p:cNvPr id="34" name="TextBox 38">
              <a:extLst>
                <a:ext uri="{FF2B5EF4-FFF2-40B4-BE49-F238E27FC236}">
                  <a16:creationId xmlns:a16="http://schemas.microsoft.com/office/drawing/2014/main" id="{F3A62FA0-735B-9F42-BC24-685364204E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10219" y="360417"/>
              <a:ext cx="1423052" cy="5847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en-US" sz="1600" dirty="0">
                  <a:ea typeface="ＭＳ Ｐゴシック" charset="-128"/>
                  <a:cs typeface="ＭＳ Ｐゴシック" charset="-128"/>
                </a:rPr>
                <a:t>Mapping and variant calling </a:t>
              </a:r>
              <a:endParaRPr lang="en-US" altLang="en-US" sz="1600" baseline="30000" dirty="0">
                <a:ea typeface="ＭＳ Ｐゴシック" charset="-128"/>
                <a:cs typeface="ＭＳ Ｐゴシック" charset="-128"/>
              </a:endParaRPr>
            </a:p>
          </p:txBody>
        </p:sp>
        <p:sp>
          <p:nvSpPr>
            <p:cNvPr id="35" name="TextBox 38">
              <a:extLst>
                <a:ext uri="{FF2B5EF4-FFF2-40B4-BE49-F238E27FC236}">
                  <a16:creationId xmlns:a16="http://schemas.microsoft.com/office/drawing/2014/main" id="{57EE2196-BF6C-AA43-9752-D7ED2C1640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17309" y="413788"/>
              <a:ext cx="1423052" cy="350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altLang="en-US" sz="1600" dirty="0">
                  <a:ea typeface="ＭＳ Ｐゴシック" charset="-128"/>
                  <a:cs typeface="ＭＳ Ｐゴシック" charset="-128"/>
                </a:rPr>
                <a:t>Variants </a:t>
              </a:r>
              <a:endParaRPr lang="en-US" altLang="en-US" sz="1600" baseline="30000" dirty="0">
                <a:ea typeface="ＭＳ Ｐゴシック" charset="-128"/>
                <a:cs typeface="ＭＳ Ｐゴシック" charset="-128"/>
              </a:endParaRPr>
            </a:p>
          </p:txBody>
        </p:sp>
        <p:cxnSp>
          <p:nvCxnSpPr>
            <p:cNvPr id="38" name="Elbow Connector 37">
              <a:extLst>
                <a:ext uri="{FF2B5EF4-FFF2-40B4-BE49-F238E27FC236}">
                  <a16:creationId xmlns:a16="http://schemas.microsoft.com/office/drawing/2014/main" id="{F9341071-627E-9340-B68A-C206D3759A17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782571" y="1738533"/>
              <a:ext cx="2343348" cy="559920"/>
            </a:xfrm>
            <a:prstGeom prst="bentConnector3">
              <a:avLst/>
            </a:prstGeom>
            <a:ln w="762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C467D49D-1F8E-9542-BD1C-3FF3C166DE64}"/>
                </a:ext>
              </a:extLst>
            </p:cNvPr>
            <p:cNvSpPr/>
            <p:nvPr/>
          </p:nvSpPr>
          <p:spPr>
            <a:xfrm>
              <a:off x="7583065" y="1720178"/>
              <a:ext cx="2605609" cy="9828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Down Arrow 46">
              <a:extLst>
                <a:ext uri="{FF2B5EF4-FFF2-40B4-BE49-F238E27FC236}">
                  <a16:creationId xmlns:a16="http://schemas.microsoft.com/office/drawing/2014/main" id="{8385B4A2-7C92-654D-B971-8C8A016CB56A}"/>
                </a:ext>
              </a:extLst>
            </p:cNvPr>
            <p:cNvSpPr/>
            <p:nvPr/>
          </p:nvSpPr>
          <p:spPr>
            <a:xfrm rot="4327112">
              <a:off x="8443588" y="1002523"/>
              <a:ext cx="528612" cy="2380127"/>
            </a:xfrm>
            <a:prstGeom prst="down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38A9F456-41E4-DB47-8281-BF76D4E016A4}"/>
                </a:ext>
              </a:extLst>
            </p:cNvPr>
            <p:cNvSpPr/>
            <p:nvPr/>
          </p:nvSpPr>
          <p:spPr>
            <a:xfrm rot="20497130">
              <a:off x="7747108" y="1972193"/>
              <a:ext cx="2220662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sz="1400" dirty="0">
                  <a:latin typeface="Arial" panose="020B0604020202020204" pitchFamily="34" charset="0"/>
                  <a:cs typeface="Arial" panose="020B0604020202020204" pitchFamily="34" charset="0"/>
                </a:rPr>
                <a:t>Select informative SNPs 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E3485CFB-C285-F24D-A5F2-0E030BA23089}"/>
              </a:ext>
            </a:extLst>
          </p:cNvPr>
          <p:cNvSpPr/>
          <p:nvPr/>
        </p:nvSpPr>
        <p:spPr>
          <a:xfrm>
            <a:off x="10767276" y="6332398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776464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801CDCF2-7E57-324F-B4F4-705E6E006A2B}"/>
              </a:ext>
            </a:extLst>
          </p:cNvPr>
          <p:cNvGrpSpPr/>
          <p:nvPr/>
        </p:nvGrpSpPr>
        <p:grpSpPr>
          <a:xfrm>
            <a:off x="168441" y="162011"/>
            <a:ext cx="11057022" cy="6328611"/>
            <a:chOff x="0" y="251971"/>
            <a:chExt cx="12107424" cy="6461805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CDAD23D-9C2D-FE41-9B8B-BFEA01CA6693}"/>
                </a:ext>
              </a:extLst>
            </p:cNvPr>
            <p:cNvGrpSpPr/>
            <p:nvPr/>
          </p:nvGrpSpPr>
          <p:grpSpPr>
            <a:xfrm>
              <a:off x="0" y="251971"/>
              <a:ext cx="12107424" cy="6461805"/>
              <a:chOff x="0" y="251971"/>
              <a:chExt cx="12107424" cy="6461805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E8F44CE6-889A-6341-91DF-32395CEC3000}"/>
                  </a:ext>
                </a:extLst>
              </p:cNvPr>
              <p:cNvPicPr/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286119"/>
                <a:ext cx="9056606" cy="6247299"/>
              </a:xfrm>
              <a:prstGeom prst="rect">
                <a:avLst/>
              </a:prstGeom>
              <a:noFill/>
              <a:ln>
                <a:noFill/>
              </a:ln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9FA3E92B-EC24-4441-B1BE-97ED4F8AF464}"/>
                  </a:ext>
                </a:extLst>
              </p:cNvPr>
              <p:cNvGrpSpPr/>
              <p:nvPr/>
            </p:nvGrpSpPr>
            <p:grpSpPr>
              <a:xfrm>
                <a:off x="7522354" y="3748133"/>
                <a:ext cx="4585070" cy="2965643"/>
                <a:chOff x="733537" y="303243"/>
                <a:chExt cx="5123417" cy="5160599"/>
              </a:xfrm>
            </p:grpSpPr>
            <p:grpSp>
              <p:nvGrpSpPr>
                <p:cNvPr id="23" name="Group 22">
                  <a:extLst>
                    <a:ext uri="{FF2B5EF4-FFF2-40B4-BE49-F238E27FC236}">
                      <a16:creationId xmlns:a16="http://schemas.microsoft.com/office/drawing/2014/main" id="{5593E0A8-D7EB-9F42-A789-FC676ED0050C}"/>
                    </a:ext>
                  </a:extLst>
                </p:cNvPr>
                <p:cNvGrpSpPr/>
                <p:nvPr/>
              </p:nvGrpSpPr>
              <p:grpSpPr>
                <a:xfrm>
                  <a:off x="733537" y="388980"/>
                  <a:ext cx="5123417" cy="5074862"/>
                  <a:chOff x="2973445" y="458984"/>
                  <a:chExt cx="6052129" cy="6083184"/>
                </a:xfrm>
              </p:grpSpPr>
              <p:cxnSp>
                <p:nvCxnSpPr>
                  <p:cNvPr id="26" name="Straight Connector 25">
                    <a:extLst>
                      <a:ext uri="{FF2B5EF4-FFF2-40B4-BE49-F238E27FC236}">
                        <a16:creationId xmlns:a16="http://schemas.microsoft.com/office/drawing/2014/main" id="{B44324AD-2336-4E4A-A257-6B5E21B7D9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051672" y="1749831"/>
                    <a:ext cx="0" cy="479233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9" name="Group 28">
                    <a:extLst>
                      <a:ext uri="{FF2B5EF4-FFF2-40B4-BE49-F238E27FC236}">
                        <a16:creationId xmlns:a16="http://schemas.microsoft.com/office/drawing/2014/main" id="{824ED9E5-8D9C-D841-8D4D-01EFA7BED0C3}"/>
                      </a:ext>
                    </a:extLst>
                  </p:cNvPr>
                  <p:cNvGrpSpPr/>
                  <p:nvPr/>
                </p:nvGrpSpPr>
                <p:grpSpPr>
                  <a:xfrm>
                    <a:off x="2973445" y="458984"/>
                    <a:ext cx="6052129" cy="6075531"/>
                    <a:chOff x="1464134" y="982664"/>
                    <a:chExt cx="6052129" cy="6075532"/>
                  </a:xfrm>
                </p:grpSpPr>
                <p:sp>
                  <p:nvSpPr>
                    <p:cNvPr id="32" name="Rectangle 31">
                      <a:extLst>
                        <a:ext uri="{FF2B5EF4-FFF2-40B4-BE49-F238E27FC236}">
                          <a16:creationId xmlns:a16="http://schemas.microsoft.com/office/drawing/2014/main" id="{6423B9C6-0765-2641-AF6E-3E60F6BD496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35336" y="4812726"/>
                      <a:ext cx="324353" cy="23076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2400"/>
                    </a:p>
                  </p:txBody>
                </p:sp>
                <p:sp>
                  <p:nvSpPr>
                    <p:cNvPr id="33" name="Rectangle 32">
                      <a:extLst>
                        <a:ext uri="{FF2B5EF4-FFF2-40B4-BE49-F238E27FC236}">
                          <a16:creationId xmlns:a16="http://schemas.microsoft.com/office/drawing/2014/main" id="{0C3E4F3C-9841-A743-A82A-0C7E9F96093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199486" y="4722231"/>
                      <a:ext cx="378929" cy="7461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2400"/>
                    </a:p>
                  </p:txBody>
                </p:sp>
                <p:pic>
                  <p:nvPicPr>
                    <p:cNvPr id="34" name="Picture 33">
                      <a:extLst>
                        <a:ext uri="{FF2B5EF4-FFF2-40B4-BE49-F238E27FC236}">
                          <a16:creationId xmlns:a16="http://schemas.microsoft.com/office/drawing/2014/main" id="{140FF737-7C6A-9447-BA8D-F4479E3B014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464134" y="1505322"/>
                      <a:ext cx="5991901" cy="5552874"/>
                    </a:xfrm>
                    <a:prstGeom prst="rect">
                      <a:avLst/>
                    </a:prstGeom>
                  </p:spPr>
                </p:pic>
                <p:cxnSp>
                  <p:nvCxnSpPr>
                    <p:cNvPr id="35" name="Straight Arrow Connector 34">
                      <a:extLst>
                        <a:ext uri="{FF2B5EF4-FFF2-40B4-BE49-F238E27FC236}">
                          <a16:creationId xmlns:a16="http://schemas.microsoft.com/office/drawing/2014/main" id="{86259D5E-C0D9-4C44-AEBF-5D5C5635945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842561" y="5029426"/>
                      <a:ext cx="1254951" cy="0"/>
                    </a:xfrm>
                    <a:prstGeom prst="straightConnector1">
                      <a:avLst/>
                    </a:prstGeom>
                    <a:ln w="28575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6" name="Rectangle 35">
                      <a:extLst>
                        <a:ext uri="{FF2B5EF4-FFF2-40B4-BE49-F238E27FC236}">
                          <a16:creationId xmlns:a16="http://schemas.microsoft.com/office/drawing/2014/main" id="{BE549482-2D4E-DF4F-8E04-9623DE7D4C5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063148" y="5059624"/>
                      <a:ext cx="1291127" cy="962975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Ps at</a:t>
                      </a:r>
                    </a:p>
                    <a:p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locus</a:t>
                      </a:r>
                    </a:p>
                  </p:txBody>
                </p:sp>
                <p:sp>
                  <p:nvSpPr>
                    <p:cNvPr id="37" name="Rectangle 36">
                      <a:extLst>
                        <a:ext uri="{FF2B5EF4-FFF2-40B4-BE49-F238E27FC236}">
                          <a16:creationId xmlns:a16="http://schemas.microsoft.com/office/drawing/2014/main" id="{86416104-E2BE-0F4D-AC86-8996064C439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631771" y="1425576"/>
                      <a:ext cx="5884492" cy="511158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sz="2400"/>
                    </a:p>
                  </p:txBody>
                </p:sp>
                <p:pic>
                  <p:nvPicPr>
                    <p:cNvPr id="38" name="Picture 2" descr="http://software.broadinstitute.org/software/igv/sites/cancerinformatics.org.igv/files/images/IGVlogo.png">
                      <a:extLst>
                        <a:ext uri="{FF2B5EF4-FFF2-40B4-BE49-F238E27FC236}">
                          <a16:creationId xmlns:a16="http://schemas.microsoft.com/office/drawing/2014/main" id="{F644A9AC-2724-8748-BA8D-2C157A014144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657350" y="982664"/>
                      <a:ext cx="1428750" cy="885825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</p:grpSp>
            <p:sp>
              <p:nvSpPr>
                <p:cNvPr id="24" name="Rectangle 23">
                  <a:extLst>
                    <a:ext uri="{FF2B5EF4-FFF2-40B4-BE49-F238E27FC236}">
                      <a16:creationId xmlns:a16="http://schemas.microsoft.com/office/drawing/2014/main" id="{D8669993-5E93-F348-9C6E-F755CDAB60FD}"/>
                    </a:ext>
                  </a:extLst>
                </p:cNvPr>
                <p:cNvSpPr/>
                <p:nvPr/>
              </p:nvSpPr>
              <p:spPr>
                <a:xfrm>
                  <a:off x="733537" y="303243"/>
                  <a:ext cx="2287015" cy="91047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9D60E18F-14E6-D34F-A14E-80E2940A56AF}"/>
                  </a:ext>
                </a:extLst>
              </p:cNvPr>
              <p:cNvSpPr/>
              <p:nvPr/>
            </p:nvSpPr>
            <p:spPr>
              <a:xfrm>
                <a:off x="6686243" y="4959769"/>
                <a:ext cx="751597" cy="129266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square">
                <a:spAutoFit/>
              </a:bodyPr>
              <a:lstStyle/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ta 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nalysis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" name="Straight Arrow Connector 3">
                <a:extLst>
                  <a:ext uri="{FF2B5EF4-FFF2-40B4-BE49-F238E27FC236}">
                    <a16:creationId xmlns:a16="http://schemas.microsoft.com/office/drawing/2014/main" id="{A83AB3C0-7783-2443-A9E3-9F9D8F2CE2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03352" y="5569596"/>
                <a:ext cx="834488" cy="0"/>
              </a:xfrm>
              <a:prstGeom prst="straightConnector1">
                <a:avLst/>
              </a:prstGeom>
              <a:ln w="28575">
                <a:solidFill>
                  <a:srgbClr val="8E8E9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1DC2E934-EFDF-3943-A5CF-A614FEEC4F42}"/>
                  </a:ext>
                </a:extLst>
              </p:cNvPr>
              <p:cNvSpPr/>
              <p:nvPr/>
            </p:nvSpPr>
            <p:spPr>
              <a:xfrm>
                <a:off x="7307922" y="1516878"/>
                <a:ext cx="2135181" cy="10464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rimary multiplex PCR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20 multiplex reactions) 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ith each multiplex contains 8-10 primer pairs</a:t>
                </a:r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AD2527A0-2D14-C748-BA55-8811DA53C339}"/>
                  </a:ext>
                </a:extLst>
              </p:cNvPr>
              <p:cNvSpPr/>
              <p:nvPr/>
            </p:nvSpPr>
            <p:spPr>
              <a:xfrm>
                <a:off x="7307922" y="2520164"/>
                <a:ext cx="1945499" cy="73866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A4804896-9185-7C4F-9726-410F1CB4CC10}"/>
                  </a:ext>
                </a:extLst>
              </p:cNvPr>
              <p:cNvSpPr/>
              <p:nvPr/>
            </p:nvSpPr>
            <p:spPr>
              <a:xfrm>
                <a:off x="673607" y="3625161"/>
                <a:ext cx="5705627" cy="6463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CR products of each sample were combined from 20 multiplex reactions and purified using QIAquick 96 PCR purification kit) </a:t>
                </a:r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A6BAFDAF-F2AD-0F4C-AD7D-797E3543C84E}"/>
                  </a:ext>
                </a:extLst>
              </p:cNvPr>
              <p:cNvSpPr/>
              <p:nvPr/>
            </p:nvSpPr>
            <p:spPr>
              <a:xfrm rot="17798196">
                <a:off x="-48998" y="5014222"/>
                <a:ext cx="1680503" cy="83099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econdary PCR to add Illumina index  primers (MID)</a:t>
                </a: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64BC07D8-B350-E244-9524-61BE4A62AB5F}"/>
                  </a:ext>
                </a:extLst>
              </p:cNvPr>
              <p:cNvSpPr/>
              <p:nvPr/>
            </p:nvSpPr>
            <p:spPr>
              <a:xfrm rot="17798196">
                <a:off x="706547" y="5888970"/>
                <a:ext cx="671018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57C93237-990F-7647-84B6-84676AB11220}"/>
                  </a:ext>
                </a:extLst>
              </p:cNvPr>
              <p:cNvSpPr/>
              <p:nvPr/>
            </p:nvSpPr>
            <p:spPr>
              <a:xfrm>
                <a:off x="3225662" y="5132906"/>
                <a:ext cx="873661" cy="6463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ooled 96 samples </a:t>
                </a: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EECBCD74-F4A8-6941-BE91-2069E6DE4A6F}"/>
                  </a:ext>
                </a:extLst>
              </p:cNvPr>
              <p:cNvSpPr/>
              <p:nvPr/>
            </p:nvSpPr>
            <p:spPr>
              <a:xfrm>
                <a:off x="3727669" y="5813514"/>
                <a:ext cx="1210953" cy="67710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Library preparation</a:t>
                </a:r>
              </a:p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728A51DA-5A69-0F4F-B4C7-8A09354A125F}"/>
                  </a:ext>
                </a:extLst>
              </p:cNvPr>
              <p:cNvSpPr/>
              <p:nvPr/>
            </p:nvSpPr>
            <p:spPr>
              <a:xfrm>
                <a:off x="5755951" y="5582681"/>
                <a:ext cx="873661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Seq</a:t>
                </a: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9A2F78FA-EB8A-5642-80A2-912CD6AB87DC}"/>
                  </a:ext>
                </a:extLst>
              </p:cNvPr>
              <p:cNvSpPr/>
              <p:nvPr/>
            </p:nvSpPr>
            <p:spPr>
              <a:xfrm>
                <a:off x="5057700" y="6088809"/>
                <a:ext cx="1903242" cy="46166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endParaRPr lang="en-US" sz="12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CA2C1B98-3182-AE4D-8C6E-A9D4D0D0D184}"/>
                  </a:ext>
                </a:extLst>
              </p:cNvPr>
              <p:cNvSpPr/>
              <p:nvPr/>
            </p:nvSpPr>
            <p:spPr>
              <a:xfrm>
                <a:off x="4313429" y="5253054"/>
                <a:ext cx="1228415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equencing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C412709E-7F33-A048-B786-427E98F6645A}"/>
                  </a:ext>
                </a:extLst>
              </p:cNvPr>
              <p:cNvSpPr/>
              <p:nvPr/>
            </p:nvSpPr>
            <p:spPr>
              <a:xfrm>
                <a:off x="10271665" y="3694728"/>
                <a:ext cx="159851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ference sequence</a:t>
                </a:r>
              </a:p>
            </p:txBody>
          </p: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2F906311-6450-6D48-A7D8-61D272DFC7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54317" y="3957739"/>
                <a:ext cx="1" cy="427473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0335DEB5-1DDA-2647-B287-C04BB02AE9EB}"/>
                  </a:ext>
                </a:extLst>
              </p:cNvPr>
              <p:cNvSpPr/>
              <p:nvPr/>
            </p:nvSpPr>
            <p:spPr>
              <a:xfrm>
                <a:off x="7203623" y="4107128"/>
                <a:ext cx="378630" cy="33855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AU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E.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AE6E143E-ADAC-CB47-95F0-50E3D0696BEB}"/>
                  </a:ext>
                </a:extLst>
              </p:cNvPr>
              <p:cNvSpPr/>
              <p:nvPr/>
            </p:nvSpPr>
            <p:spPr>
              <a:xfrm>
                <a:off x="5213943" y="4479993"/>
                <a:ext cx="389850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AU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D.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B71EA4B0-1ECA-ED40-9702-C7CFC991C66A}"/>
                  </a:ext>
                </a:extLst>
              </p:cNvPr>
              <p:cNvSpPr/>
              <p:nvPr/>
            </p:nvSpPr>
            <p:spPr>
              <a:xfrm>
                <a:off x="3958134" y="4697579"/>
                <a:ext cx="389850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AU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.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8E98E118-30FA-424F-A8A4-DBFE61591086}"/>
                  </a:ext>
                </a:extLst>
              </p:cNvPr>
              <p:cNvSpPr/>
              <p:nvPr/>
            </p:nvSpPr>
            <p:spPr>
              <a:xfrm>
                <a:off x="1273643" y="4876774"/>
                <a:ext cx="378630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AU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B.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71D01F07-9216-5B40-9935-9FDD5B73A951}"/>
                  </a:ext>
                </a:extLst>
              </p:cNvPr>
              <p:cNvSpPr/>
              <p:nvPr/>
            </p:nvSpPr>
            <p:spPr>
              <a:xfrm>
                <a:off x="137175" y="251971"/>
                <a:ext cx="378630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AU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A.</a:t>
                </a:r>
                <a:endParaRPr 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F1BA2F91-7899-FE47-91B3-A0DA455F19FA}"/>
                </a:ext>
              </a:extLst>
            </p:cNvPr>
            <p:cNvCxnSpPr>
              <a:cxnSpLocks/>
            </p:cNvCxnSpPr>
            <p:nvPr/>
          </p:nvCxnSpPr>
          <p:spPr>
            <a:xfrm>
              <a:off x="4379455" y="5516018"/>
              <a:ext cx="834488" cy="0"/>
            </a:xfrm>
            <a:prstGeom prst="straightConnector1">
              <a:avLst/>
            </a:prstGeom>
            <a:ln w="28575">
              <a:solidFill>
                <a:srgbClr val="8E8E9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E62363AC-75DD-BB43-9DB6-B665D0D44191}"/>
              </a:ext>
            </a:extLst>
          </p:cNvPr>
          <p:cNvSpPr/>
          <p:nvPr/>
        </p:nvSpPr>
        <p:spPr>
          <a:xfrm>
            <a:off x="10752056" y="6513100"/>
            <a:ext cx="11935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29877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Diagram 6">
            <a:extLst>
              <a:ext uri="{FF2B5EF4-FFF2-40B4-BE49-F238E27FC236}">
                <a16:creationId xmlns:a16="http://schemas.microsoft.com/office/drawing/2014/main" id="{7CC0146C-7ECC-6B45-A8AE-A257A563EE64}"/>
              </a:ext>
            </a:extLst>
          </p:cNvPr>
          <p:cNvGraphicFramePr>
            <a:graphicFrameLocks/>
          </p:cNvGraphicFramePr>
          <p:nvPr/>
        </p:nvGraphicFramePr>
        <p:xfrm>
          <a:off x="2895601" y="550888"/>
          <a:ext cx="6635262" cy="575622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1F1398DF-F5DA-224A-84BF-A27F28B98003}"/>
              </a:ext>
            </a:extLst>
          </p:cNvPr>
          <p:cNvSpPr/>
          <p:nvPr/>
        </p:nvSpPr>
        <p:spPr>
          <a:xfrm>
            <a:off x="10715961" y="6307111"/>
            <a:ext cx="11935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7413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BE43D028-11ED-D640-BDF7-FF51E658EF6E}"/>
              </a:ext>
            </a:extLst>
          </p:cNvPr>
          <p:cNvGrpSpPr/>
          <p:nvPr/>
        </p:nvGrpSpPr>
        <p:grpSpPr>
          <a:xfrm>
            <a:off x="14053" y="8496"/>
            <a:ext cx="5087815" cy="4998934"/>
            <a:chOff x="0" y="387306"/>
            <a:chExt cx="6353908" cy="6481419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904E5CAD-1371-A540-8ED3-149C02BE08F7}"/>
                </a:ext>
              </a:extLst>
            </p:cNvPr>
            <p:cNvGrpSpPr/>
            <p:nvPr/>
          </p:nvGrpSpPr>
          <p:grpSpPr>
            <a:xfrm>
              <a:off x="0" y="785446"/>
              <a:ext cx="6353908" cy="6083279"/>
              <a:chOff x="1347292" y="320191"/>
              <a:chExt cx="6235036" cy="5750145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0BB82A88-AFBA-6E40-89E9-E910EE4A33F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47292" y="320191"/>
                <a:ext cx="6235036" cy="5740007"/>
              </a:xfrm>
              <a:prstGeom prst="rect">
                <a:avLst/>
              </a:prstGeom>
            </p:spPr>
          </p:pic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A06B6DD4-A236-6F4F-8061-562F31304EDF}"/>
                  </a:ext>
                </a:extLst>
              </p:cNvPr>
              <p:cNvCxnSpPr/>
              <p:nvPr/>
            </p:nvCxnSpPr>
            <p:spPr>
              <a:xfrm>
                <a:off x="2784297" y="1078786"/>
                <a:ext cx="15822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AB56CEB0-16EB-AC42-AAEA-70730D3E7441}"/>
                  </a:ext>
                </a:extLst>
              </p:cNvPr>
              <p:cNvSpPr/>
              <p:nvPr/>
            </p:nvSpPr>
            <p:spPr>
              <a:xfrm>
                <a:off x="2805105" y="821931"/>
                <a:ext cx="1422658" cy="3134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-valu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 = 0.13</a:t>
                </a:r>
              </a:p>
            </p:txBody>
          </p: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D6AA3A3E-624F-6141-9D8B-62659E935E6B}"/>
                  </a:ext>
                </a:extLst>
              </p:cNvPr>
              <p:cNvCxnSpPr/>
              <p:nvPr/>
            </p:nvCxnSpPr>
            <p:spPr>
              <a:xfrm>
                <a:off x="5385370" y="1098931"/>
                <a:ext cx="15822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AFEE6EC0-18D2-814A-9CA9-B67B2670E799}"/>
                  </a:ext>
                </a:extLst>
              </p:cNvPr>
              <p:cNvSpPr/>
              <p:nvPr/>
            </p:nvSpPr>
            <p:spPr>
              <a:xfrm>
                <a:off x="5494962" y="806723"/>
                <a:ext cx="1422658" cy="3134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-valu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 = 0.92</a:t>
                </a:r>
              </a:p>
            </p:txBody>
          </p: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BC0A7038-F22E-2449-9A6E-16F2909DA3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67486" y="685529"/>
                <a:ext cx="2491526" cy="409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8C601AE6-35FB-504E-B8B7-D5F99FE8D3F7}"/>
                  </a:ext>
                </a:extLst>
              </p:cNvPr>
              <p:cNvSpPr/>
              <p:nvPr/>
            </p:nvSpPr>
            <p:spPr>
              <a:xfrm>
                <a:off x="4132801" y="422489"/>
                <a:ext cx="1452915" cy="31348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-valu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e = 0.47</a:t>
                </a:r>
              </a:p>
            </p:txBody>
          </p:sp>
          <p:sp>
            <p:nvSpPr>
              <p:cNvPr id="66" name="Rectangle 65">
                <a:extLst>
                  <a:ext uri="{FF2B5EF4-FFF2-40B4-BE49-F238E27FC236}">
                    <a16:creationId xmlns:a16="http://schemas.microsoft.com/office/drawing/2014/main" id="{1CF87CFB-28FD-8140-A7E8-435228D7498B}"/>
                  </a:ext>
                </a:extLst>
              </p:cNvPr>
              <p:cNvSpPr/>
              <p:nvPr/>
            </p:nvSpPr>
            <p:spPr>
              <a:xfrm>
                <a:off x="2355461" y="4293947"/>
                <a:ext cx="4768661" cy="177638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D31D45E9-F926-4242-A6BA-036628B05E82}"/>
                  </a:ext>
                </a:extLst>
              </p:cNvPr>
              <p:cNvSpPr/>
              <p:nvPr/>
            </p:nvSpPr>
            <p:spPr>
              <a:xfrm>
                <a:off x="2182839" y="4047091"/>
                <a:ext cx="5352836" cy="34852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MOI1          MOI1_rWGA        MOI2      MOI2-rWGA</a:t>
                </a:r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B6D1B2F7-F251-E64A-9261-1E7B4F129641}"/>
                  </a:ext>
                </a:extLst>
              </p:cNvPr>
              <p:cNvSpPr/>
              <p:nvPr/>
            </p:nvSpPr>
            <p:spPr>
              <a:xfrm>
                <a:off x="3561483" y="4389908"/>
                <a:ext cx="2165222" cy="34831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Sample Genotyped </a:t>
                </a:r>
              </a:p>
            </p:txBody>
          </p:sp>
          <p:sp>
            <p:nvSpPr>
              <p:cNvPr id="69" name="Rectangle 68">
                <a:extLst>
                  <a:ext uri="{FF2B5EF4-FFF2-40B4-BE49-F238E27FC236}">
                    <a16:creationId xmlns:a16="http://schemas.microsoft.com/office/drawing/2014/main" id="{54CBA0C9-CE11-834F-8209-615053641F1B}"/>
                  </a:ext>
                </a:extLst>
              </p:cNvPr>
              <p:cNvSpPr/>
              <p:nvPr/>
            </p:nvSpPr>
            <p:spPr>
              <a:xfrm>
                <a:off x="1347292" y="539534"/>
                <a:ext cx="871088" cy="38357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en-US" sz="1600" b="1" i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814747C8-0CC4-1F4F-A2F7-2A1C92444F4D}"/>
                  </a:ext>
                </a:extLst>
              </p:cNvPr>
              <p:cNvSpPr/>
              <p:nvPr/>
            </p:nvSpPr>
            <p:spPr>
              <a:xfrm>
                <a:off x="2009427" y="3908422"/>
                <a:ext cx="330422" cy="3134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C6F72450-A862-E041-ADB7-2CE58DCAF2AD}"/>
                  </a:ext>
                </a:extLst>
              </p:cNvPr>
              <p:cNvSpPr/>
              <p:nvPr/>
            </p:nvSpPr>
            <p:spPr>
              <a:xfrm>
                <a:off x="2009427" y="3090445"/>
                <a:ext cx="330422" cy="3134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72" name="Rectangle 71">
                <a:extLst>
                  <a:ext uri="{FF2B5EF4-FFF2-40B4-BE49-F238E27FC236}">
                    <a16:creationId xmlns:a16="http://schemas.microsoft.com/office/drawing/2014/main" id="{E40D7BBE-48F7-3640-9F57-3A67FF62DB9D}"/>
                  </a:ext>
                </a:extLst>
              </p:cNvPr>
              <p:cNvSpPr/>
              <p:nvPr/>
            </p:nvSpPr>
            <p:spPr>
              <a:xfrm>
                <a:off x="1902533" y="2209781"/>
                <a:ext cx="434537" cy="3134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73" name="Rectangle 72">
                <a:extLst>
                  <a:ext uri="{FF2B5EF4-FFF2-40B4-BE49-F238E27FC236}">
                    <a16:creationId xmlns:a16="http://schemas.microsoft.com/office/drawing/2014/main" id="{702CA1C0-3D01-5045-B728-B0EF5DDD6DD5}"/>
                  </a:ext>
                </a:extLst>
              </p:cNvPr>
              <p:cNvSpPr/>
              <p:nvPr/>
            </p:nvSpPr>
            <p:spPr>
              <a:xfrm>
                <a:off x="1902533" y="1350788"/>
                <a:ext cx="434537" cy="3134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4E50A57A-BBCA-7445-A372-71D7191C6E65}"/>
                  </a:ext>
                </a:extLst>
              </p:cNvPr>
              <p:cNvSpPr/>
              <p:nvPr/>
            </p:nvSpPr>
            <p:spPr>
              <a:xfrm>
                <a:off x="1905047" y="523560"/>
                <a:ext cx="434537" cy="31348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EC7B2CA0-B45C-5845-BA2D-AD5B8A1EBEE6}"/>
                  </a:ext>
                </a:extLst>
              </p:cNvPr>
              <p:cNvSpPr/>
              <p:nvPr/>
            </p:nvSpPr>
            <p:spPr>
              <a:xfrm rot="16200000">
                <a:off x="563750" y="2186770"/>
                <a:ext cx="2438545" cy="37717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</a:t>
                </a:r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lang="en-US" sz="1400" i="0" dirty="0">
                    <a:latin typeface="Arial" panose="020B0604020202020204" pitchFamily="34" charset="0"/>
                    <a:cs typeface="Arial" panose="020B0604020202020204" pitchFamily="34" charset="0"/>
                  </a:rPr>
                  <a:t>oci amplified </a:t>
                </a:r>
              </a:p>
            </p:txBody>
          </p:sp>
        </p:grp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470AD590-713E-DE4C-84F4-F2043A2A03C6}"/>
                </a:ext>
              </a:extLst>
            </p:cNvPr>
            <p:cNvSpPr/>
            <p:nvPr/>
          </p:nvSpPr>
          <p:spPr>
            <a:xfrm>
              <a:off x="184400" y="387306"/>
              <a:ext cx="614986" cy="5527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</p:grpSp>
      <p:pic>
        <p:nvPicPr>
          <p:cNvPr id="27" name="Picture 26">
            <a:extLst>
              <a:ext uri="{FF2B5EF4-FFF2-40B4-BE49-F238E27FC236}">
                <a16:creationId xmlns:a16="http://schemas.microsoft.com/office/drawing/2014/main" id="{54F636BA-4E12-2647-93F9-AE2F1B7291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71982" y="536018"/>
            <a:ext cx="6118170" cy="3100258"/>
          </a:xfrm>
          <a:prstGeom prst="rect">
            <a:avLst/>
          </a:prstGeom>
        </p:spPr>
      </p:pic>
      <p:sp>
        <p:nvSpPr>
          <p:cNvPr id="77" name="Rectangle 76">
            <a:extLst>
              <a:ext uri="{FF2B5EF4-FFF2-40B4-BE49-F238E27FC236}">
                <a16:creationId xmlns:a16="http://schemas.microsoft.com/office/drawing/2014/main" id="{D08AA132-9559-444F-BE5D-51B5D2CCACD9}"/>
              </a:ext>
            </a:extLst>
          </p:cNvPr>
          <p:cNvSpPr/>
          <p:nvPr/>
        </p:nvSpPr>
        <p:spPr>
          <a:xfrm>
            <a:off x="6501077" y="3366907"/>
            <a:ext cx="5589075" cy="2693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1   WGA1   S2   WGA2   S3   WGA3  S4   WGA4  S5   WGA5    S6    WGA6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A81B4527-3694-024B-9984-310CC34AA8ED}"/>
              </a:ext>
            </a:extLst>
          </p:cNvPr>
          <p:cNvSpPr/>
          <p:nvPr/>
        </p:nvSpPr>
        <p:spPr>
          <a:xfrm>
            <a:off x="5893454" y="783869"/>
            <a:ext cx="284424" cy="19126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0CABF9D9-0F3B-944A-BDA1-168E97AB2DA2}"/>
              </a:ext>
            </a:extLst>
          </p:cNvPr>
          <p:cNvSpPr/>
          <p:nvPr/>
        </p:nvSpPr>
        <p:spPr>
          <a:xfrm rot="16200000">
            <a:off x="4859366" y="1870131"/>
            <a:ext cx="2544011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       200     300      400    500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9DB5002A-9E93-054E-9865-B8DCB75B7796}"/>
              </a:ext>
            </a:extLst>
          </p:cNvPr>
          <p:cNvSpPr/>
          <p:nvPr/>
        </p:nvSpPr>
        <p:spPr>
          <a:xfrm rot="16200000">
            <a:off x="4993137" y="1847271"/>
            <a:ext cx="151355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ad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coverage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8CBB3E8A-825D-7748-969F-DD0CF83F396F}"/>
              </a:ext>
            </a:extLst>
          </p:cNvPr>
          <p:cNvSpPr/>
          <p:nvPr/>
        </p:nvSpPr>
        <p:spPr>
          <a:xfrm>
            <a:off x="5686624" y="293093"/>
            <a:ext cx="49244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B8DE5C1D-6F85-4C48-AF45-0C8DC2895D8A}"/>
              </a:ext>
            </a:extLst>
          </p:cNvPr>
          <p:cNvGrpSpPr/>
          <p:nvPr/>
        </p:nvGrpSpPr>
        <p:grpSpPr>
          <a:xfrm>
            <a:off x="-198227" y="4069463"/>
            <a:ext cx="6468098" cy="2781379"/>
            <a:chOff x="4713917" y="1003936"/>
            <a:chExt cx="6468098" cy="2781379"/>
          </a:xfrm>
        </p:grpSpPr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B00896F4-AF25-AA45-AA3F-96D0356BAC0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2006" y="2627128"/>
              <a:ext cx="279780" cy="7354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82" name="Chart 81">
              <a:extLst>
                <a:ext uri="{FF2B5EF4-FFF2-40B4-BE49-F238E27FC236}">
                  <a16:creationId xmlns:a16="http://schemas.microsoft.com/office/drawing/2014/main" id="{918B90B9-6F33-C441-8631-2B581AA6C631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713917" y="1263999"/>
            <a:ext cx="4442050" cy="252131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4E43226F-43F8-1C49-BC10-6E4507960E20}"/>
                </a:ext>
              </a:extLst>
            </p:cNvPr>
            <p:cNvSpPr/>
            <p:nvPr/>
          </p:nvSpPr>
          <p:spPr>
            <a:xfrm>
              <a:off x="5878569" y="1749415"/>
              <a:ext cx="910827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ailed in </a:t>
              </a:r>
            </a:p>
            <a:p>
              <a:r>
                <a:rPr lang="en-US" sz="1400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  <a:r>
                <a:rPr lang="en-US" sz="1400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R </a:t>
              </a:r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13461C3D-419A-2547-97BE-DDACA46B0B6D}"/>
                </a:ext>
              </a:extLst>
            </p:cNvPr>
            <p:cNvSpPr/>
            <p:nvPr/>
          </p:nvSpPr>
          <p:spPr>
            <a:xfrm>
              <a:off x="5971895" y="1462844"/>
              <a:ext cx="468398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r>
                <a:rPr lang="en-US" sz="2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01ABEC06-F24A-284E-BF3D-D6B584FE7C9A}"/>
                </a:ext>
              </a:extLst>
            </p:cNvPr>
            <p:cNvSpPr/>
            <p:nvPr/>
          </p:nvSpPr>
          <p:spPr>
            <a:xfrm>
              <a:off x="6580688" y="2507615"/>
              <a:ext cx="48282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8</a:t>
              </a:r>
            </a:p>
          </p:txBody>
        </p:sp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EF68322A-696B-6C46-822B-CF8B70D66EE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067723" y="1474709"/>
              <a:ext cx="3114292" cy="21646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6DC006FA-0302-6840-A0F3-10F28DD5EB88}"/>
                </a:ext>
              </a:extLst>
            </p:cNvPr>
            <p:cNvSpPr/>
            <p:nvPr/>
          </p:nvSpPr>
          <p:spPr>
            <a:xfrm>
              <a:off x="8960786" y="1836458"/>
              <a:ext cx="613032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1623A92F-71D3-2543-AA0D-EB7C68BFD0BA}"/>
                </a:ext>
              </a:extLst>
            </p:cNvPr>
            <p:cNvSpPr/>
            <p:nvPr/>
          </p:nvSpPr>
          <p:spPr>
            <a:xfrm>
              <a:off x="8914443" y="2755332"/>
              <a:ext cx="526106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46</a:t>
              </a:r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843316DA-8434-6E49-85B2-28B2E78F6424}"/>
                </a:ext>
              </a:extLst>
            </p:cNvPr>
            <p:cNvSpPr/>
            <p:nvPr/>
          </p:nvSpPr>
          <p:spPr>
            <a:xfrm>
              <a:off x="9919612" y="3479047"/>
              <a:ext cx="270787" cy="13543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160B2C2A-ECE2-AF45-8A5A-68D455B4C9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87468" y="1459862"/>
              <a:ext cx="1694602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32EB6734-4938-0B42-87BB-D6C4CABE71C7}"/>
                </a:ext>
              </a:extLst>
            </p:cNvPr>
            <p:cNvSpPr/>
            <p:nvPr/>
          </p:nvSpPr>
          <p:spPr>
            <a:xfrm>
              <a:off x="9554736" y="1885823"/>
              <a:ext cx="144055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ailed QC</a:t>
              </a:r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1CC6402C-CF11-B64A-BFA5-120CDD719237}"/>
                </a:ext>
              </a:extLst>
            </p:cNvPr>
            <p:cNvSpPr/>
            <p:nvPr/>
          </p:nvSpPr>
          <p:spPr>
            <a:xfrm>
              <a:off x="9818835" y="2912054"/>
              <a:ext cx="1293070" cy="37965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endParaRPr lang="en-US" sz="186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9B249FD8-DC91-9040-AAB2-B7D2D6CF5080}"/>
                </a:ext>
              </a:extLst>
            </p:cNvPr>
            <p:cNvSpPr/>
            <p:nvPr/>
          </p:nvSpPr>
          <p:spPr>
            <a:xfrm>
              <a:off x="9534252" y="2627128"/>
              <a:ext cx="1292927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ccessfully Genotyped </a:t>
              </a: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423F4C16-5F5D-C541-8064-5C8EF3CB0C88}"/>
                </a:ext>
              </a:extLst>
            </p:cNvPr>
            <p:cNvSpPr/>
            <p:nvPr/>
          </p:nvSpPr>
          <p:spPr>
            <a:xfrm>
              <a:off x="5062805" y="1003936"/>
              <a:ext cx="49244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3F81DC95-E64C-CA48-A91F-5DD54ABC923A}"/>
                </a:ext>
              </a:extLst>
            </p:cNvPr>
            <p:cNvSpPr/>
            <p:nvPr/>
          </p:nvSpPr>
          <p:spPr>
            <a:xfrm>
              <a:off x="9039138" y="3479047"/>
              <a:ext cx="241524" cy="1318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9FF2C40E-2CEB-E649-A54B-8E7D3BECE24D}"/>
                </a:ext>
              </a:extLst>
            </p:cNvPr>
            <p:cNvCxnSpPr>
              <a:cxnSpLocks/>
            </p:cNvCxnSpPr>
            <p:nvPr/>
          </p:nvCxnSpPr>
          <p:spPr>
            <a:xfrm>
              <a:off x="7140826" y="3640607"/>
              <a:ext cx="1763977" cy="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5C00B3B4-AD6A-5740-95BD-0CCE9B2BA1A1}"/>
              </a:ext>
            </a:extLst>
          </p:cNvPr>
          <p:cNvSpPr/>
          <p:nvPr/>
        </p:nvSpPr>
        <p:spPr>
          <a:xfrm>
            <a:off x="9963318" y="6060390"/>
            <a:ext cx="13436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6620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DE758CA2-8129-A74C-BA0B-29B9B60ACA84}"/>
              </a:ext>
            </a:extLst>
          </p:cNvPr>
          <p:cNvGrpSpPr/>
          <p:nvPr/>
        </p:nvGrpSpPr>
        <p:grpSpPr>
          <a:xfrm>
            <a:off x="2659083" y="841006"/>
            <a:ext cx="6081461" cy="4729655"/>
            <a:chOff x="2069535" y="588343"/>
            <a:chExt cx="6081461" cy="4729655"/>
          </a:xfrm>
        </p:grpSpPr>
        <p:pic>
          <p:nvPicPr>
            <p:cNvPr id="1025" name="Picture 2" descr="/var/folders/pp/10_28st534jf84mwmgy6dyxw0002h3/T/com.microsoft.Word/WebArchiveCopyPasteTempFiles/plot.png?width=764&amp;height=511&amp;randomizer=1261472088">
              <a:extLst>
                <a:ext uri="{FF2B5EF4-FFF2-40B4-BE49-F238E27FC236}">
                  <a16:creationId xmlns:a16="http://schemas.microsoft.com/office/drawing/2014/main" id="{32D4509C-DE05-FD49-848A-D24CA974B28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r:link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7480" y="588343"/>
              <a:ext cx="5883516" cy="472965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4C37444-CFE9-2B41-A82F-2DC9F6E0A12C}"/>
                </a:ext>
              </a:extLst>
            </p:cNvPr>
            <p:cNvSpPr/>
            <p:nvPr/>
          </p:nvSpPr>
          <p:spPr>
            <a:xfrm>
              <a:off x="4066799" y="4827745"/>
              <a:ext cx="2326150" cy="3385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inor Allele Frequency 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A21A3400-6A08-D64E-86BA-5133E2E3C107}"/>
                </a:ext>
              </a:extLst>
            </p:cNvPr>
            <p:cNvSpPr/>
            <p:nvPr/>
          </p:nvSpPr>
          <p:spPr>
            <a:xfrm>
              <a:off x="3761438" y="797062"/>
              <a:ext cx="2509520" cy="42777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03AAC152-3C3B-404A-B194-2BB05FF6D5D3}"/>
                </a:ext>
              </a:extLst>
            </p:cNvPr>
            <p:cNvSpPr/>
            <p:nvPr/>
          </p:nvSpPr>
          <p:spPr>
            <a:xfrm rot="16200000">
              <a:off x="941216" y="2496444"/>
              <a:ext cx="25951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umber of SNPs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0060DA35-8CE0-E04F-8439-6B425954DFE7}"/>
                </a:ext>
              </a:extLst>
            </p:cNvPr>
            <p:cNvSpPr/>
            <p:nvPr/>
          </p:nvSpPr>
          <p:spPr>
            <a:xfrm>
              <a:off x="2680779" y="4491380"/>
              <a:ext cx="519589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0             0.1                0.2            0.3             0.4               0.5 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DF0405AA-FC0E-FB4E-B399-2AC80E56DAF7}"/>
                </a:ext>
              </a:extLst>
            </p:cNvPr>
            <p:cNvSpPr/>
            <p:nvPr/>
          </p:nvSpPr>
          <p:spPr>
            <a:xfrm rot="16200000">
              <a:off x="1132452" y="2859694"/>
              <a:ext cx="274412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endParaRPr lang="en-US" sz="1400" dirty="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5D4EB4C-9578-644D-80D7-716A9A310A1C}"/>
                </a:ext>
              </a:extLst>
            </p:cNvPr>
            <p:cNvSpPr/>
            <p:nvPr/>
          </p:nvSpPr>
          <p:spPr>
            <a:xfrm>
              <a:off x="2407025" y="4091069"/>
              <a:ext cx="28405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dirty="0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52BA542-F624-CC4A-9981-30D95159F669}"/>
                </a:ext>
              </a:extLst>
            </p:cNvPr>
            <p:cNvSpPr/>
            <p:nvPr/>
          </p:nvSpPr>
          <p:spPr>
            <a:xfrm>
              <a:off x="2410715" y="3635659"/>
              <a:ext cx="28405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400" dirty="0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4BA62688-0F44-CA49-AFD1-5FEDDE362251}"/>
                </a:ext>
              </a:extLst>
            </p:cNvPr>
            <p:cNvSpPr/>
            <p:nvPr/>
          </p:nvSpPr>
          <p:spPr>
            <a:xfrm>
              <a:off x="2336469" y="3139688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1400" dirty="0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5BDD1EE9-5F8E-C846-BCBA-595EBAEF6003}"/>
                </a:ext>
              </a:extLst>
            </p:cNvPr>
            <p:cNvSpPr/>
            <p:nvPr/>
          </p:nvSpPr>
          <p:spPr>
            <a:xfrm>
              <a:off x="2312796" y="2620847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sz="1400" dirty="0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31BEAEDD-7775-054C-8D86-AEEA57325165}"/>
                </a:ext>
              </a:extLst>
            </p:cNvPr>
            <p:cNvSpPr/>
            <p:nvPr/>
          </p:nvSpPr>
          <p:spPr>
            <a:xfrm>
              <a:off x="2312796" y="2095773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1400" dirty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9EBD3BC-8449-6E4C-9995-2E48474A076B}"/>
                </a:ext>
              </a:extLst>
            </p:cNvPr>
            <p:cNvSpPr/>
            <p:nvPr/>
          </p:nvSpPr>
          <p:spPr>
            <a:xfrm>
              <a:off x="2312796" y="1620083"/>
              <a:ext cx="38343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1400" dirty="0"/>
            </a:p>
          </p:txBody>
        </p:sp>
      </p:grpSp>
      <p:sp>
        <p:nvSpPr>
          <p:cNvPr id="35" name="Rectangle 34">
            <a:extLst>
              <a:ext uri="{FF2B5EF4-FFF2-40B4-BE49-F238E27FC236}">
                <a16:creationId xmlns:a16="http://schemas.microsoft.com/office/drawing/2014/main" id="{5594866D-C9BF-7A4C-9E48-9B1CFC21E7AF}"/>
              </a:ext>
            </a:extLst>
          </p:cNvPr>
          <p:cNvSpPr/>
          <p:nvPr/>
        </p:nvSpPr>
        <p:spPr>
          <a:xfrm>
            <a:off x="9963318" y="6060390"/>
            <a:ext cx="13436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93844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806784A-06F0-DE4B-839E-F6C173B887B8}"/>
              </a:ext>
            </a:extLst>
          </p:cNvPr>
          <p:cNvGrpSpPr/>
          <p:nvPr/>
        </p:nvGrpSpPr>
        <p:grpSpPr>
          <a:xfrm>
            <a:off x="1042414" y="1407319"/>
            <a:ext cx="10034148" cy="3731821"/>
            <a:chOff x="214752" y="256303"/>
            <a:chExt cx="9469602" cy="2812737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9DF4B5B0-3650-AA43-B6BA-66C004EBB51E}"/>
                </a:ext>
              </a:extLst>
            </p:cNvPr>
            <p:cNvSpPr/>
            <p:nvPr/>
          </p:nvSpPr>
          <p:spPr>
            <a:xfrm rot="16200000">
              <a:off x="-139148" y="1125743"/>
              <a:ext cx="1046353" cy="3385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elta K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AFF3BC1-65B9-FB46-8BFB-3E45EFB14B2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32737" y="389995"/>
              <a:ext cx="2922053" cy="2340492"/>
            </a:xfrm>
            <a:prstGeom prst="rect">
              <a:avLst/>
            </a:prstGeom>
          </p:spPr>
        </p:pic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C7E8FA8E-63B3-B145-A0E4-9CB98FD94F36}"/>
                </a:ext>
              </a:extLst>
            </p:cNvPr>
            <p:cNvGrpSpPr/>
            <p:nvPr/>
          </p:nvGrpSpPr>
          <p:grpSpPr>
            <a:xfrm>
              <a:off x="495707" y="389998"/>
              <a:ext cx="3423444" cy="2651281"/>
              <a:chOff x="134952" y="1288681"/>
              <a:chExt cx="3423443" cy="2651281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6305B074-93F7-744A-B911-DCE485F54B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2025" y="1315895"/>
                <a:ext cx="3055815" cy="2291861"/>
              </a:xfrm>
              <a:prstGeom prst="rect">
                <a:avLst/>
              </a:prstGeom>
            </p:spPr>
          </p:pic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301170D9-0B39-7842-A158-FB1288AE4549}"/>
                  </a:ext>
                </a:extLst>
              </p:cNvPr>
              <p:cNvSpPr/>
              <p:nvPr/>
            </p:nvSpPr>
            <p:spPr>
              <a:xfrm>
                <a:off x="559168" y="3439292"/>
                <a:ext cx="2867636" cy="2561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sz="14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        10        15        20</a:t>
                </a: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CBCCBB3C-F22A-5D43-92A1-AC0A5A0EFDD1}"/>
                  </a:ext>
                </a:extLst>
              </p:cNvPr>
              <p:cNvSpPr/>
              <p:nvPr/>
            </p:nvSpPr>
            <p:spPr>
              <a:xfrm>
                <a:off x="1797063" y="3601408"/>
                <a:ext cx="462279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</a:p>
            </p:txBody>
          </p: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FD3A77DD-A3B5-5B4F-8893-05514F88D0FE}"/>
                  </a:ext>
                </a:extLst>
              </p:cNvPr>
              <p:cNvGrpSpPr/>
              <p:nvPr/>
            </p:nvGrpSpPr>
            <p:grpSpPr>
              <a:xfrm>
                <a:off x="134952" y="1449329"/>
                <a:ext cx="406622" cy="1891696"/>
                <a:chOff x="246076" y="1005079"/>
                <a:chExt cx="406622" cy="1891696"/>
              </a:xfrm>
            </p:grpSpPr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051F8952-2247-C84D-B987-6FA5F295207D}"/>
                    </a:ext>
                  </a:extLst>
                </p:cNvPr>
                <p:cNvSpPr/>
                <p:nvPr/>
              </p:nvSpPr>
              <p:spPr>
                <a:xfrm rot="16200000">
                  <a:off x="-444487" y="1802687"/>
                  <a:ext cx="1877250" cy="28203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24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62CBB930-9329-894A-BEB7-593C108DEE52}"/>
                    </a:ext>
                  </a:extLst>
                </p:cNvPr>
                <p:cNvSpPr/>
                <p:nvPr/>
              </p:nvSpPr>
              <p:spPr>
                <a:xfrm>
                  <a:off x="246076" y="1040579"/>
                  <a:ext cx="383438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8B8157AD-E9E2-5C4D-A5EA-B2C1B0CBFFCF}"/>
                    </a:ext>
                  </a:extLst>
                </p:cNvPr>
                <p:cNvSpPr/>
                <p:nvPr/>
              </p:nvSpPr>
              <p:spPr>
                <a:xfrm>
                  <a:off x="258134" y="1444693"/>
                  <a:ext cx="383438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2B654E33-54C7-E540-A206-DFC7C061955C}"/>
                    </a:ext>
                  </a:extLst>
                </p:cNvPr>
                <p:cNvSpPr/>
                <p:nvPr/>
              </p:nvSpPr>
              <p:spPr>
                <a:xfrm>
                  <a:off x="269260" y="1838565"/>
                  <a:ext cx="383438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29948FFE-2F16-7141-A91D-0A94DA68FEEC}"/>
                    </a:ext>
                  </a:extLst>
                </p:cNvPr>
                <p:cNvSpPr/>
                <p:nvPr/>
              </p:nvSpPr>
              <p:spPr>
                <a:xfrm>
                  <a:off x="327653" y="2242678"/>
                  <a:ext cx="284052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</a:p>
              </p:txBody>
            </p:sp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4B59466C-8CE7-B34A-B0FB-CB4ABADA0263}"/>
                    </a:ext>
                  </a:extLst>
                </p:cNvPr>
                <p:cNvSpPr/>
                <p:nvPr/>
              </p:nvSpPr>
              <p:spPr>
                <a:xfrm>
                  <a:off x="342116" y="2588998"/>
                  <a:ext cx="284052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</p:grp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BC25228A-51BD-394D-AEC8-6D4C46876BDD}"/>
                  </a:ext>
                </a:extLst>
              </p:cNvPr>
              <p:cNvSpPr/>
              <p:nvPr/>
            </p:nvSpPr>
            <p:spPr>
              <a:xfrm>
                <a:off x="690759" y="1288681"/>
                <a:ext cx="2867636" cy="2561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>
                    <a:solidFill>
                      <a:schemeClr val="tx1"/>
                    </a:solidFill>
                  </a:rPr>
                  <a:t>              </a:t>
                </a:r>
              </a:p>
            </p:txBody>
          </p:sp>
        </p:grp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7B52970B-F82A-C342-80CF-F95DF9FDE2B0}"/>
                </a:ext>
              </a:extLst>
            </p:cNvPr>
            <p:cNvSpPr/>
            <p:nvPr/>
          </p:nvSpPr>
          <p:spPr>
            <a:xfrm>
              <a:off x="6596477" y="2554842"/>
              <a:ext cx="2611631" cy="2561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5         10       15       20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95DECD15-D0DB-5548-9846-7B60E4C2FBFA}"/>
                </a:ext>
              </a:extLst>
            </p:cNvPr>
            <p:cNvSpPr/>
            <p:nvPr/>
          </p:nvSpPr>
          <p:spPr>
            <a:xfrm>
              <a:off x="7833402" y="2730487"/>
              <a:ext cx="393784" cy="3385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F2E4797C-33D2-E447-BE57-A10CBA279763}"/>
                </a:ext>
              </a:extLst>
            </p:cNvPr>
            <p:cNvGrpSpPr/>
            <p:nvPr/>
          </p:nvGrpSpPr>
          <p:grpSpPr>
            <a:xfrm>
              <a:off x="6142757" y="642391"/>
              <a:ext cx="417717" cy="1941391"/>
              <a:chOff x="246199" y="921523"/>
              <a:chExt cx="417719" cy="1941392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25D9E1FE-687A-EF4A-8887-DE83F00CE2C1}"/>
                  </a:ext>
                </a:extLst>
              </p:cNvPr>
              <p:cNvSpPr/>
              <p:nvPr/>
            </p:nvSpPr>
            <p:spPr>
              <a:xfrm rot="16200000">
                <a:off x="-437452" y="1783273"/>
                <a:ext cx="1877250" cy="28203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03EE76C7-C025-6C46-A4AC-79FC13563847}"/>
                  </a:ext>
                </a:extLst>
              </p:cNvPr>
              <p:cNvSpPr/>
              <p:nvPr/>
            </p:nvSpPr>
            <p:spPr>
              <a:xfrm>
                <a:off x="246199" y="921523"/>
                <a:ext cx="3834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2EA78BAF-6FDF-3A4E-A341-1ABE10350C6B}"/>
                  </a:ext>
                </a:extLst>
              </p:cNvPr>
              <p:cNvSpPr/>
              <p:nvPr/>
            </p:nvSpPr>
            <p:spPr>
              <a:xfrm>
                <a:off x="258752" y="1328922"/>
                <a:ext cx="3834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A039BBA8-41F0-834D-8318-63BEA1DCF752}"/>
                  </a:ext>
                </a:extLst>
              </p:cNvPr>
              <p:cNvSpPr/>
              <p:nvPr/>
            </p:nvSpPr>
            <p:spPr>
              <a:xfrm>
                <a:off x="276927" y="1684746"/>
                <a:ext cx="3834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BF5C36E2-36AB-444D-B69E-B59CD6E785D5}"/>
                  </a:ext>
                </a:extLst>
              </p:cNvPr>
              <p:cNvSpPr/>
              <p:nvPr/>
            </p:nvSpPr>
            <p:spPr>
              <a:xfrm>
                <a:off x="273241" y="2104200"/>
                <a:ext cx="3834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14E8E85E-57DF-E247-8ED4-8BF2A23AE8F3}"/>
                  </a:ext>
                </a:extLst>
              </p:cNvPr>
              <p:cNvSpPr/>
              <p:nvPr/>
            </p:nvSpPr>
            <p:spPr>
              <a:xfrm>
                <a:off x="379866" y="2459627"/>
                <a:ext cx="284052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</p:grp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54DAE1CC-0DF6-AA45-935E-401015F5D9A5}"/>
                </a:ext>
              </a:extLst>
            </p:cNvPr>
            <p:cNvSpPr/>
            <p:nvPr/>
          </p:nvSpPr>
          <p:spPr>
            <a:xfrm rot="16200000">
              <a:off x="5553029" y="1483743"/>
              <a:ext cx="1046353" cy="3385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elta K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D4FBB188-69F4-EA43-8448-464D88FC3EF9}"/>
                </a:ext>
              </a:extLst>
            </p:cNvPr>
            <p:cNvSpPr/>
            <p:nvPr/>
          </p:nvSpPr>
          <p:spPr>
            <a:xfrm>
              <a:off x="6816718" y="502862"/>
              <a:ext cx="2867636" cy="25612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>
                  <a:solidFill>
                    <a:schemeClr val="tx1"/>
                  </a:solidFill>
                </a:rPr>
                <a:t>              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C1E0C12E-3203-7241-8DE9-611D6D032AA1}"/>
                </a:ext>
              </a:extLst>
            </p:cNvPr>
            <p:cNvCxnSpPr>
              <a:cxnSpLocks/>
            </p:cNvCxnSpPr>
            <p:nvPr/>
          </p:nvCxnSpPr>
          <p:spPr>
            <a:xfrm>
              <a:off x="906606" y="605159"/>
              <a:ext cx="0" cy="1933576"/>
            </a:xfrm>
            <a:prstGeom prst="line">
              <a:avLst/>
            </a:prstGeom>
            <a:ln w="19050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5AD6BBB-A073-2744-B750-3736D49667D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14187" y="2526255"/>
              <a:ext cx="2425100" cy="7013"/>
            </a:xfrm>
            <a:prstGeom prst="line">
              <a:avLst/>
            </a:prstGeom>
            <a:ln w="19050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884E487A-EF23-5544-9446-918FB93EF452}"/>
                </a:ext>
              </a:extLst>
            </p:cNvPr>
            <p:cNvCxnSpPr>
              <a:cxnSpLocks/>
            </p:cNvCxnSpPr>
            <p:nvPr/>
          </p:nvCxnSpPr>
          <p:spPr>
            <a:xfrm>
              <a:off x="6549683" y="605159"/>
              <a:ext cx="0" cy="1939656"/>
            </a:xfrm>
            <a:prstGeom prst="line">
              <a:avLst/>
            </a:prstGeom>
            <a:ln w="19050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A7E1CE62-F7AB-A64E-A37D-B0EF1E1E753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546329" y="2547702"/>
              <a:ext cx="2425100" cy="7013"/>
            </a:xfrm>
            <a:prstGeom prst="line">
              <a:avLst/>
            </a:prstGeom>
            <a:ln w="19050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C28A4309-ADEF-0D42-A739-19BAF17E1F8D}"/>
                </a:ext>
              </a:extLst>
            </p:cNvPr>
            <p:cNvSpPr/>
            <p:nvPr/>
          </p:nvSpPr>
          <p:spPr>
            <a:xfrm>
              <a:off x="454443" y="256303"/>
              <a:ext cx="2347464" cy="3479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. SNP barcode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AA763AD7-BEED-4D4B-A980-F1DBD3807E51}"/>
                </a:ext>
              </a:extLst>
            </p:cNvPr>
            <p:cNvSpPr/>
            <p:nvPr/>
          </p:nvSpPr>
          <p:spPr>
            <a:xfrm>
              <a:off x="6073773" y="259863"/>
              <a:ext cx="2401138" cy="3479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B. Microsatellite</a:t>
              </a:r>
            </a:p>
          </p:txBody>
        </p:sp>
      </p:grpSp>
      <p:sp>
        <p:nvSpPr>
          <p:cNvPr id="36" name="Rectangle 35">
            <a:extLst>
              <a:ext uri="{FF2B5EF4-FFF2-40B4-BE49-F238E27FC236}">
                <a16:creationId xmlns:a16="http://schemas.microsoft.com/office/drawing/2014/main" id="{005B80FC-27FF-6346-8A71-E90C9EAD5204}"/>
              </a:ext>
            </a:extLst>
          </p:cNvPr>
          <p:cNvSpPr/>
          <p:nvPr/>
        </p:nvSpPr>
        <p:spPr>
          <a:xfrm>
            <a:off x="9963318" y="6060390"/>
            <a:ext cx="13436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48149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1A5214D-9256-D944-8A8A-1AF9F6B29F16}"/>
              </a:ext>
            </a:extLst>
          </p:cNvPr>
          <p:cNvGrpSpPr/>
          <p:nvPr/>
        </p:nvGrpSpPr>
        <p:grpSpPr>
          <a:xfrm>
            <a:off x="1105117" y="992094"/>
            <a:ext cx="9550183" cy="5090261"/>
            <a:chOff x="279153" y="751745"/>
            <a:chExt cx="8522008" cy="401890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3C10D1A-0872-4A49-B3E2-0283B7C7A11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9153" y="751745"/>
              <a:ext cx="8522008" cy="4018901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45692A9-1419-AB42-B6DB-454A15E3345C}"/>
                </a:ext>
              </a:extLst>
            </p:cNvPr>
            <p:cNvSpPr/>
            <p:nvPr/>
          </p:nvSpPr>
          <p:spPr>
            <a:xfrm rot="16200000">
              <a:off x="-684342" y="2193205"/>
              <a:ext cx="223476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roportion of genotypes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73C4FF2C-DC9C-2C4D-BF85-4F95EE80F191}"/>
                </a:ext>
              </a:extLst>
            </p:cNvPr>
            <p:cNvSpPr/>
            <p:nvPr/>
          </p:nvSpPr>
          <p:spPr>
            <a:xfrm>
              <a:off x="1181996" y="4449330"/>
              <a:ext cx="2767266" cy="2672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roportion of shared alleles 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C9E03A37-887D-354D-8B73-BA8077A20D19}"/>
                </a:ext>
              </a:extLst>
            </p:cNvPr>
            <p:cNvSpPr/>
            <p:nvPr/>
          </p:nvSpPr>
          <p:spPr>
            <a:xfrm rot="16200000">
              <a:off x="3586191" y="2178306"/>
              <a:ext cx="2234767" cy="30210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roportion of genotypes 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E5EC313A-B56A-A842-BCA8-F17D17D7DE71}"/>
                </a:ext>
              </a:extLst>
            </p:cNvPr>
            <p:cNvSpPr/>
            <p:nvPr/>
          </p:nvSpPr>
          <p:spPr>
            <a:xfrm>
              <a:off x="5516173" y="4390267"/>
              <a:ext cx="2767266" cy="2672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roportion of shared alleles 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35814C8C-B3C6-D244-81FF-8F7F0AD3D186}"/>
                </a:ext>
              </a:extLst>
            </p:cNvPr>
            <p:cNvSpPr/>
            <p:nvPr/>
          </p:nvSpPr>
          <p:spPr>
            <a:xfrm>
              <a:off x="555589" y="1064173"/>
              <a:ext cx="602759" cy="1655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800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9B18264F-186F-E04D-8B28-EA349C434760}"/>
                </a:ext>
              </a:extLst>
            </p:cNvPr>
            <p:cNvSpPr/>
            <p:nvPr/>
          </p:nvSpPr>
          <p:spPr>
            <a:xfrm>
              <a:off x="4560636" y="963669"/>
              <a:ext cx="1411099" cy="2483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80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1B3AEB3A-C453-0648-A5AE-9CCBDDD19E00}"/>
                </a:ext>
              </a:extLst>
            </p:cNvPr>
            <p:cNvSpPr/>
            <p:nvPr/>
          </p:nvSpPr>
          <p:spPr>
            <a:xfrm>
              <a:off x="4560636" y="888611"/>
              <a:ext cx="2510664" cy="3644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B. Microsatellites </a:t>
              </a: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C5CE4ACD-38B2-3A44-99FB-1945AE43A16F}"/>
              </a:ext>
            </a:extLst>
          </p:cNvPr>
          <p:cNvSpPr/>
          <p:nvPr/>
        </p:nvSpPr>
        <p:spPr>
          <a:xfrm>
            <a:off x="3160059" y="1030979"/>
            <a:ext cx="2272553" cy="7422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B669616-C293-2C42-8837-59C1341E1AF2}"/>
              </a:ext>
            </a:extLst>
          </p:cNvPr>
          <p:cNvSpPr/>
          <p:nvPr/>
        </p:nvSpPr>
        <p:spPr>
          <a:xfrm>
            <a:off x="1172850" y="1156977"/>
            <a:ext cx="248741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. SNP barcode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1F935D9-9B4F-8040-98F1-6DE05A1B9EF6}"/>
              </a:ext>
            </a:extLst>
          </p:cNvPr>
          <p:cNvSpPr/>
          <p:nvPr/>
        </p:nvSpPr>
        <p:spPr>
          <a:xfrm>
            <a:off x="10129034" y="6384576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04319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155A03B-D29B-714E-821C-D8688F181839}"/>
              </a:ext>
            </a:extLst>
          </p:cNvPr>
          <p:cNvGrpSpPr/>
          <p:nvPr/>
        </p:nvGrpSpPr>
        <p:grpSpPr>
          <a:xfrm>
            <a:off x="814999" y="0"/>
            <a:ext cx="9965295" cy="5895474"/>
            <a:chOff x="213421" y="0"/>
            <a:chExt cx="11680129" cy="656568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FC9C99C-E0F2-D440-8629-2EEC5EE532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8450" y="0"/>
              <a:ext cx="11595100" cy="6542189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85DF5FC6-83F5-474B-8A67-D085D726AC06}"/>
                </a:ext>
              </a:extLst>
            </p:cNvPr>
            <p:cNvSpPr/>
            <p:nvPr/>
          </p:nvSpPr>
          <p:spPr>
            <a:xfrm>
              <a:off x="2743200" y="279400"/>
              <a:ext cx="7747000" cy="355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CAC61294-D3F2-D64E-8B20-203DDF26D16A}"/>
                </a:ext>
              </a:extLst>
            </p:cNvPr>
            <p:cNvSpPr/>
            <p:nvPr/>
          </p:nvSpPr>
          <p:spPr>
            <a:xfrm>
              <a:off x="5486400" y="5898835"/>
              <a:ext cx="2007683" cy="6668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icrosatellite 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  <a:p>
              <a:endParaRPr lang="en-US" sz="16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0E3DA9F-F377-D647-AF1A-9F1B1397A3F4}"/>
                </a:ext>
              </a:extLst>
            </p:cNvPr>
            <p:cNvSpPr/>
            <p:nvPr/>
          </p:nvSpPr>
          <p:spPr>
            <a:xfrm>
              <a:off x="1861549" y="5559187"/>
              <a:ext cx="9707728" cy="3427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00        0.11            0.22         0.33           0.43          0.56         0.67          0.78         0.89         1.00           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49B207B9-FCAC-AC41-A63A-63056EECF75F}"/>
                </a:ext>
              </a:extLst>
            </p:cNvPr>
            <p:cNvSpPr/>
            <p:nvPr/>
          </p:nvSpPr>
          <p:spPr>
            <a:xfrm rot="16200000">
              <a:off x="-456996" y="2344411"/>
              <a:ext cx="2007683" cy="6668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SNP </a:t>
              </a:r>
              <a:r>
                <a:rPr lang="en-US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6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  <a:p>
              <a:endParaRPr lang="en-US" sz="16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6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855BB48D-1052-A54C-BD27-970714A55FCD}"/>
                </a:ext>
              </a:extLst>
            </p:cNvPr>
            <p:cNvSpPr/>
            <p:nvPr/>
          </p:nvSpPr>
          <p:spPr>
            <a:xfrm>
              <a:off x="546846" y="4744729"/>
              <a:ext cx="53251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30</a:t>
              </a:r>
              <a:endParaRPr lang="en-US" sz="1400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48000C89-DD47-584D-9D0A-B4B1535575F7}"/>
                </a:ext>
              </a:extLst>
            </p:cNvPr>
            <p:cNvSpPr/>
            <p:nvPr/>
          </p:nvSpPr>
          <p:spPr>
            <a:xfrm>
              <a:off x="521310" y="4098441"/>
              <a:ext cx="53251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40</a:t>
              </a:r>
              <a:endParaRPr lang="en-US" sz="1400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17C9B28-E36E-3F45-A5DD-0DB820DDCB9A}"/>
                </a:ext>
              </a:extLst>
            </p:cNvPr>
            <p:cNvSpPr/>
            <p:nvPr/>
          </p:nvSpPr>
          <p:spPr>
            <a:xfrm>
              <a:off x="508610" y="3420683"/>
              <a:ext cx="53251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50</a:t>
              </a:r>
              <a:endParaRPr lang="en-US" sz="1400" dirty="0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64CB9998-1014-0944-AD2F-710AEB52CCEF}"/>
                </a:ext>
              </a:extLst>
            </p:cNvPr>
            <p:cNvSpPr/>
            <p:nvPr/>
          </p:nvSpPr>
          <p:spPr>
            <a:xfrm>
              <a:off x="546846" y="2742925"/>
              <a:ext cx="53251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60</a:t>
              </a:r>
              <a:endParaRPr lang="en-US" sz="1400" dirty="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F8BE9CA0-7141-1142-A85B-5D7B9F91DB82}"/>
                </a:ext>
              </a:extLst>
            </p:cNvPr>
            <p:cNvSpPr/>
            <p:nvPr/>
          </p:nvSpPr>
          <p:spPr>
            <a:xfrm>
              <a:off x="508474" y="2027559"/>
              <a:ext cx="53251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70</a:t>
              </a:r>
              <a:endParaRPr lang="en-US" sz="1400" dirty="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753605A0-39CD-314F-AD93-EA7172E597CB}"/>
                </a:ext>
              </a:extLst>
            </p:cNvPr>
            <p:cNvSpPr/>
            <p:nvPr/>
          </p:nvSpPr>
          <p:spPr>
            <a:xfrm>
              <a:off x="521310" y="1284712"/>
              <a:ext cx="53251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.80</a:t>
              </a:r>
              <a:endParaRPr lang="en-US" sz="1400" dirty="0"/>
            </a:p>
          </p:txBody>
        </p:sp>
      </p:grpSp>
      <p:sp>
        <p:nvSpPr>
          <p:cNvPr id="15" name="Rectangle 14">
            <a:extLst>
              <a:ext uri="{FF2B5EF4-FFF2-40B4-BE49-F238E27FC236}">
                <a16:creationId xmlns:a16="http://schemas.microsoft.com/office/drawing/2014/main" id="{EDDA65FB-8869-434D-8F6B-BA8C554E3194}"/>
              </a:ext>
            </a:extLst>
          </p:cNvPr>
          <p:cNvSpPr/>
          <p:nvPr/>
        </p:nvSpPr>
        <p:spPr>
          <a:xfrm>
            <a:off x="10371146" y="6285708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8494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7</TotalTime>
  <Words>330</Words>
  <Application>Microsoft Macintosh PowerPoint</Application>
  <PresentationFormat>Widescreen</PresentationFormat>
  <Paragraphs>150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la, Abebe</dc:creator>
  <cp:lastModifiedBy>Fola, Abebe</cp:lastModifiedBy>
  <cp:revision>15</cp:revision>
  <dcterms:created xsi:type="dcterms:W3CDTF">2020-02-24T16:37:33Z</dcterms:created>
  <dcterms:modified xsi:type="dcterms:W3CDTF">2020-04-04T22:07:39Z</dcterms:modified>
</cp:coreProperties>
</file>